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5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1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colorful2">
  <dgm:title val=""/>
  <dgm:desc val=""/>
  <dgm:catLst>
    <dgm:cat type="colorful" pri="10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2"/>
      <a:schemeClr val="accent3"/>
    </dgm:fillClrLst>
    <dgm:linClrLst>
      <a:schemeClr val="accent2"/>
      <a:schemeClr val="accent3"/>
    </dgm:linClrLst>
    <dgm:effectClrLst/>
    <dgm:txLinClrLst/>
    <dgm:txFillClrLst/>
    <dgm:txEffectClrLst/>
  </dgm:styleLbl>
  <dgm:styleLbl name="lnNode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2">
        <a:alpha val="50000"/>
      </a:schemeClr>
      <a:schemeClr val="accent3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2">
        <a:tint val="50000"/>
      </a:schemeClr>
      <a:schemeClr val="accent3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2">
        <a:tint val="50000"/>
      </a:schemeClr>
      <a:schemeClr val="accent3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2">
        <a:tint val="50000"/>
      </a:schemeClr>
      <a:schemeClr val="accent3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2"/>
      <a:schemeClr val="accent3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2"/>
    </dgm:fillClrLst>
    <dgm:linClrLst meth="repeat">
      <a:schemeClr val="accent2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2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3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2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2"/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2">
        <a:tint val="90000"/>
      </a:schemeClr>
    </dgm:fillClrLst>
    <dgm:linClrLst meth="repeat">
      <a:schemeClr val="accent3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2">
        <a:tint val="70000"/>
      </a:schemeClr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2">
        <a:tint val="50000"/>
      </a:schemeClr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3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5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2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2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2">
        <a:tint val="50000"/>
        <a:alpha val="40000"/>
      </a:schemeClr>
    </dgm:fillClrLst>
    <dgm:linClrLst meth="repeat">
      <a:schemeClr val="accent2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2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834A4D0A-7B4F-4359-BA93-2C13BF74EDA0}" type="doc">
      <dgm:prSet loTypeId="urn:microsoft.com/office/officeart/2005/8/layout/hProcess6" loCatId="process" qsTypeId="urn:microsoft.com/office/officeart/2005/8/quickstyle/3d1" qsCatId="3D" csTypeId="urn:microsoft.com/office/officeart/2005/8/colors/colorful2" csCatId="colorful" phldr="1"/>
      <dgm:spPr/>
      <dgm:t>
        <a:bodyPr/>
        <a:lstStyle/>
        <a:p>
          <a:endParaRPr lang="en-GB"/>
        </a:p>
      </dgm:t>
    </dgm:pt>
    <dgm:pt modelId="{5150DBBA-A014-48FD-9CA4-07146E30F64D}">
      <dgm:prSet phldrT="[Text]" custT="1"/>
      <dgm:spPr/>
      <dgm:t>
        <a:bodyPr/>
        <a:lstStyle/>
        <a:p>
          <a:r>
            <a:rPr lang="en-GB" sz="1400" dirty="0"/>
            <a:t>Anonymous </a:t>
          </a:r>
          <a:r>
            <a:rPr lang="en-GB" sz="1400" dirty="0" smtClean="0"/>
            <a:t>Data</a:t>
          </a:r>
          <a:endParaRPr lang="en-GB" sz="1400" dirty="0"/>
        </a:p>
      </dgm:t>
    </dgm:pt>
    <dgm:pt modelId="{DA971BFC-0D7A-4DE0-BDB8-E0F9EE4474A6}" type="parTrans" cxnId="{2C0DDB8A-5159-4638-A132-4CCB2119234A}">
      <dgm:prSet/>
      <dgm:spPr/>
      <dgm:t>
        <a:bodyPr/>
        <a:lstStyle/>
        <a:p>
          <a:endParaRPr lang="en-GB"/>
        </a:p>
      </dgm:t>
    </dgm:pt>
    <dgm:pt modelId="{43A8421F-1BA2-4BC0-9E74-DC3E843731A4}" type="sibTrans" cxnId="{2C0DDB8A-5159-4638-A132-4CCB2119234A}">
      <dgm:prSet/>
      <dgm:spPr/>
      <dgm:t>
        <a:bodyPr/>
        <a:lstStyle/>
        <a:p>
          <a:endParaRPr lang="en-GB"/>
        </a:p>
      </dgm:t>
    </dgm:pt>
    <dgm:pt modelId="{31FBC1D5-391B-444B-B524-94E917D06623}">
      <dgm:prSet phldrT="[Text]" custT="1"/>
      <dgm:spPr/>
      <dgm:t>
        <a:bodyPr/>
        <a:lstStyle/>
        <a:p>
          <a:endParaRPr lang="en-GB" sz="1400" dirty="0" smtClean="0"/>
        </a:p>
        <a:p>
          <a:r>
            <a:rPr lang="en-GB" sz="1400" dirty="0" smtClean="0"/>
            <a:t>Pseudo-</a:t>
          </a:r>
          <a:r>
            <a:rPr lang="en-GB" sz="1400" dirty="0" err="1" smtClean="0"/>
            <a:t>nymised</a:t>
          </a:r>
          <a:r>
            <a:rPr lang="en-GB" sz="1400" dirty="0" smtClean="0"/>
            <a:t> </a:t>
          </a:r>
        </a:p>
        <a:p>
          <a:r>
            <a:rPr lang="en-GB" sz="1400" dirty="0" smtClean="0"/>
            <a:t>Data</a:t>
          </a:r>
          <a:endParaRPr lang="en-GB" sz="1400" dirty="0"/>
        </a:p>
        <a:p>
          <a:endParaRPr lang="en-GB" sz="1400" dirty="0"/>
        </a:p>
      </dgm:t>
    </dgm:pt>
    <dgm:pt modelId="{7864CD3C-CE53-4E32-BD2C-4C96558ABF97}" type="parTrans" cxnId="{0B361C4D-EA01-4243-A76F-67E4D254019A}">
      <dgm:prSet/>
      <dgm:spPr/>
      <dgm:t>
        <a:bodyPr/>
        <a:lstStyle/>
        <a:p>
          <a:endParaRPr lang="en-GB"/>
        </a:p>
      </dgm:t>
    </dgm:pt>
    <dgm:pt modelId="{BB37BEB6-10FF-4092-B45C-1D58BC0E6A57}" type="sibTrans" cxnId="{0B361C4D-EA01-4243-A76F-67E4D254019A}">
      <dgm:prSet/>
      <dgm:spPr/>
      <dgm:t>
        <a:bodyPr/>
        <a:lstStyle/>
        <a:p>
          <a:endParaRPr lang="en-GB"/>
        </a:p>
      </dgm:t>
    </dgm:pt>
    <dgm:pt modelId="{7E15A40E-EB63-4F19-9FB6-8BC8EAB63B7A}">
      <dgm:prSet phldrT="[Text]"/>
      <dgm:spPr/>
      <dgm:t>
        <a:bodyPr/>
        <a:lstStyle/>
        <a:p>
          <a:endParaRPr lang="en-GB" sz="1100" dirty="0"/>
        </a:p>
      </dgm:t>
    </dgm:pt>
    <dgm:pt modelId="{E773C87C-F0B9-4922-85D5-B701A31C0C8A}" type="parTrans" cxnId="{31064EF3-6143-4BA2-846C-E31A1E126CEB}">
      <dgm:prSet/>
      <dgm:spPr/>
      <dgm:t>
        <a:bodyPr/>
        <a:lstStyle/>
        <a:p>
          <a:endParaRPr lang="en-GB"/>
        </a:p>
      </dgm:t>
    </dgm:pt>
    <dgm:pt modelId="{EA7471FC-5D26-49CE-95D8-A567D819342F}" type="sibTrans" cxnId="{31064EF3-6143-4BA2-846C-E31A1E126CEB}">
      <dgm:prSet/>
      <dgm:spPr/>
      <dgm:t>
        <a:bodyPr/>
        <a:lstStyle/>
        <a:p>
          <a:endParaRPr lang="en-GB"/>
        </a:p>
      </dgm:t>
    </dgm:pt>
    <dgm:pt modelId="{B20DE993-EC76-4012-921D-37ACF96121B2}">
      <dgm:prSet phldrT="[Text]" custT="1"/>
      <dgm:spPr/>
      <dgm:t>
        <a:bodyPr/>
        <a:lstStyle/>
        <a:p>
          <a:r>
            <a:rPr lang="en-GB" sz="1400" dirty="0"/>
            <a:t>Patient Identifiable </a:t>
          </a:r>
          <a:r>
            <a:rPr lang="en-GB" sz="1400" dirty="0" smtClean="0"/>
            <a:t>Data</a:t>
          </a:r>
          <a:endParaRPr lang="en-GB" sz="1400" dirty="0"/>
        </a:p>
      </dgm:t>
    </dgm:pt>
    <dgm:pt modelId="{840D9F93-76D3-4E61-A557-A3FC019B4CFC}" type="parTrans" cxnId="{52285C53-D490-4476-BDFC-825228EDAA2F}">
      <dgm:prSet/>
      <dgm:spPr/>
      <dgm:t>
        <a:bodyPr/>
        <a:lstStyle/>
        <a:p>
          <a:endParaRPr lang="en-GB"/>
        </a:p>
      </dgm:t>
    </dgm:pt>
    <dgm:pt modelId="{13E580C5-B282-40FF-A8D6-DEB9A487222B}" type="sibTrans" cxnId="{52285C53-D490-4476-BDFC-825228EDAA2F}">
      <dgm:prSet/>
      <dgm:spPr/>
      <dgm:t>
        <a:bodyPr/>
        <a:lstStyle/>
        <a:p>
          <a:endParaRPr lang="en-GB"/>
        </a:p>
      </dgm:t>
    </dgm:pt>
    <dgm:pt modelId="{07DE7DBE-459C-488B-921C-1798FD60EA0B}">
      <dgm:prSet custT="1"/>
      <dgm:spPr/>
      <dgm:t>
        <a:bodyPr/>
        <a:lstStyle/>
        <a:p>
          <a:endParaRPr lang="en-GB" sz="1200" dirty="0"/>
        </a:p>
      </dgm:t>
    </dgm:pt>
    <dgm:pt modelId="{B1C441C3-C458-41F7-AC39-47F9F3054A17}" type="parTrans" cxnId="{14C7BF01-B892-4601-A2C9-91EC9FB33D37}">
      <dgm:prSet/>
      <dgm:spPr/>
      <dgm:t>
        <a:bodyPr/>
        <a:lstStyle/>
        <a:p>
          <a:endParaRPr lang="en-GB"/>
        </a:p>
      </dgm:t>
    </dgm:pt>
    <dgm:pt modelId="{382AB4E6-9B94-47B8-88F7-7FB05D9E6319}" type="sibTrans" cxnId="{14C7BF01-B892-4601-A2C9-91EC9FB33D37}">
      <dgm:prSet/>
      <dgm:spPr/>
      <dgm:t>
        <a:bodyPr/>
        <a:lstStyle/>
        <a:p>
          <a:endParaRPr lang="en-GB"/>
        </a:p>
      </dgm:t>
    </dgm:pt>
    <dgm:pt modelId="{39955DF2-2E4B-45FB-ADC2-5CAF6E5F4AB0}">
      <dgm:prSet/>
      <dgm:spPr/>
      <dgm:t>
        <a:bodyPr/>
        <a:lstStyle/>
        <a:p>
          <a:endParaRPr lang="en-GB" sz="1000" dirty="0"/>
        </a:p>
      </dgm:t>
    </dgm:pt>
    <dgm:pt modelId="{B22DEC13-D4A3-43AC-A48D-BB57EF54B77B}" type="parTrans" cxnId="{93A8FA1D-5D79-4ED6-AD8E-43ADB8893D4B}">
      <dgm:prSet/>
      <dgm:spPr/>
      <dgm:t>
        <a:bodyPr/>
        <a:lstStyle/>
        <a:p>
          <a:endParaRPr lang="en-GB"/>
        </a:p>
      </dgm:t>
    </dgm:pt>
    <dgm:pt modelId="{C88461C2-401D-4217-866A-99764488615D}" type="sibTrans" cxnId="{93A8FA1D-5D79-4ED6-AD8E-43ADB8893D4B}">
      <dgm:prSet/>
      <dgm:spPr/>
      <dgm:t>
        <a:bodyPr/>
        <a:lstStyle/>
        <a:p>
          <a:endParaRPr lang="en-GB"/>
        </a:p>
      </dgm:t>
    </dgm:pt>
    <dgm:pt modelId="{D4496064-C95D-4831-8F40-824C439FBF33}">
      <dgm:prSet custT="1"/>
      <dgm:spPr/>
      <dgm:t>
        <a:bodyPr/>
        <a:lstStyle/>
        <a:p>
          <a:r>
            <a:rPr lang="en-GB" sz="1300" dirty="0"/>
            <a:t>Unique ID</a:t>
          </a:r>
        </a:p>
      </dgm:t>
    </dgm:pt>
    <dgm:pt modelId="{BED25DF3-7BCB-44E7-81F6-28F8F7A4A93C}" type="parTrans" cxnId="{733FF976-F2AF-4FC5-94C7-8CC1C28D5C08}">
      <dgm:prSet/>
      <dgm:spPr/>
      <dgm:t>
        <a:bodyPr/>
        <a:lstStyle/>
        <a:p>
          <a:endParaRPr lang="en-GB"/>
        </a:p>
      </dgm:t>
    </dgm:pt>
    <dgm:pt modelId="{F74E2329-75C4-42F7-93CC-763C32E36ADD}" type="sibTrans" cxnId="{733FF976-F2AF-4FC5-94C7-8CC1C28D5C08}">
      <dgm:prSet/>
      <dgm:spPr/>
      <dgm:t>
        <a:bodyPr/>
        <a:lstStyle/>
        <a:p>
          <a:endParaRPr lang="en-GB"/>
        </a:p>
      </dgm:t>
    </dgm:pt>
    <dgm:pt modelId="{2E4CFC3E-1DC3-431E-9CD7-BE4BF56F5B26}">
      <dgm:prSet phldrT="[Text]" custT="1"/>
      <dgm:spPr/>
      <dgm:t>
        <a:bodyPr/>
        <a:lstStyle/>
        <a:p>
          <a:r>
            <a:rPr lang="en-GB" sz="1300" dirty="0"/>
            <a:t>Unique ID</a:t>
          </a:r>
        </a:p>
      </dgm:t>
    </dgm:pt>
    <dgm:pt modelId="{A7DC3164-4424-48CC-A256-72614D95F963}" type="parTrans" cxnId="{58E4C5E2-84B6-4D91-A7F2-5C2258225E12}">
      <dgm:prSet/>
      <dgm:spPr/>
      <dgm:t>
        <a:bodyPr/>
        <a:lstStyle/>
        <a:p>
          <a:endParaRPr lang="en-US"/>
        </a:p>
      </dgm:t>
    </dgm:pt>
    <dgm:pt modelId="{C58881F9-02A4-4A2D-924A-BEF1361E5DCA}" type="sibTrans" cxnId="{58E4C5E2-84B6-4D91-A7F2-5C2258225E12}">
      <dgm:prSet/>
      <dgm:spPr/>
      <dgm:t>
        <a:bodyPr/>
        <a:lstStyle/>
        <a:p>
          <a:endParaRPr lang="en-US"/>
        </a:p>
      </dgm:t>
    </dgm:pt>
    <dgm:pt modelId="{57F6C132-9116-47D5-B649-218BFE557B40}">
      <dgm:prSet phldrT="[Text]" custT="1"/>
      <dgm:spPr/>
      <dgm:t>
        <a:bodyPr/>
        <a:lstStyle/>
        <a:p>
          <a:r>
            <a:rPr lang="en-GB" sz="1300" dirty="0"/>
            <a:t>Unique ID</a:t>
          </a:r>
        </a:p>
      </dgm:t>
    </dgm:pt>
    <dgm:pt modelId="{58C7C361-799C-4E35-B0AD-6307CD23FA27}" type="sibTrans" cxnId="{38A10E6E-4538-4E10-8500-0B21A31E76C6}">
      <dgm:prSet/>
      <dgm:spPr/>
      <dgm:t>
        <a:bodyPr/>
        <a:lstStyle/>
        <a:p>
          <a:endParaRPr lang="en-GB"/>
        </a:p>
      </dgm:t>
    </dgm:pt>
    <dgm:pt modelId="{1713CB1F-2096-465B-BAC3-62CF4F341950}" type="parTrans" cxnId="{38A10E6E-4538-4E10-8500-0B21A31E76C6}">
      <dgm:prSet/>
      <dgm:spPr/>
      <dgm:t>
        <a:bodyPr/>
        <a:lstStyle/>
        <a:p>
          <a:endParaRPr lang="en-GB"/>
        </a:p>
      </dgm:t>
    </dgm:pt>
    <dgm:pt modelId="{30C81DDA-E18E-4795-B88F-09B2347590A6}">
      <dgm:prSet custT="1"/>
      <dgm:spPr/>
      <dgm:t>
        <a:bodyPr/>
        <a:lstStyle/>
        <a:p>
          <a:r>
            <a:rPr lang="en-GB" sz="1300" dirty="0"/>
            <a:t>Name</a:t>
          </a:r>
        </a:p>
      </dgm:t>
    </dgm:pt>
    <dgm:pt modelId="{AB5A7CF9-78E5-4395-BCAA-D265E7FA43E5}" type="parTrans" cxnId="{43F7FE0C-BE72-4211-B47B-06DB88ABB51F}">
      <dgm:prSet/>
      <dgm:spPr/>
      <dgm:t>
        <a:bodyPr/>
        <a:lstStyle/>
        <a:p>
          <a:endParaRPr lang="en-US"/>
        </a:p>
      </dgm:t>
    </dgm:pt>
    <dgm:pt modelId="{1C99A81A-CB71-4FD8-AA02-4E58BA2D5779}" type="sibTrans" cxnId="{43F7FE0C-BE72-4211-B47B-06DB88ABB51F}">
      <dgm:prSet/>
      <dgm:spPr/>
      <dgm:t>
        <a:bodyPr/>
        <a:lstStyle/>
        <a:p>
          <a:endParaRPr lang="en-US"/>
        </a:p>
      </dgm:t>
    </dgm:pt>
    <dgm:pt modelId="{1918FBF4-E643-4F52-92A3-95107699BE21}">
      <dgm:prSet custT="1"/>
      <dgm:spPr/>
      <dgm:t>
        <a:bodyPr/>
        <a:lstStyle/>
        <a:p>
          <a:r>
            <a:rPr lang="en-GB" sz="1300" dirty="0"/>
            <a:t>Mobile Number</a:t>
          </a:r>
        </a:p>
      </dgm:t>
    </dgm:pt>
    <dgm:pt modelId="{C5A08192-E9EF-42BF-9B89-D96BA339ACEB}" type="parTrans" cxnId="{03693CC0-4C0C-48F3-B2CF-166E055BF018}">
      <dgm:prSet/>
      <dgm:spPr/>
      <dgm:t>
        <a:bodyPr/>
        <a:lstStyle/>
        <a:p>
          <a:endParaRPr lang="en-US"/>
        </a:p>
      </dgm:t>
    </dgm:pt>
    <dgm:pt modelId="{EE8BB1CD-A87B-493D-A76E-230B0391702B}" type="sibTrans" cxnId="{03693CC0-4C0C-48F3-B2CF-166E055BF018}">
      <dgm:prSet/>
      <dgm:spPr/>
      <dgm:t>
        <a:bodyPr/>
        <a:lstStyle/>
        <a:p>
          <a:endParaRPr lang="en-US"/>
        </a:p>
      </dgm:t>
    </dgm:pt>
    <dgm:pt modelId="{46C1AEE6-768F-4176-BE10-A23DB5BE1D2B}">
      <dgm:prSet phldrT="[Text]" custT="1"/>
      <dgm:spPr/>
      <dgm:t>
        <a:bodyPr/>
        <a:lstStyle/>
        <a:p>
          <a:r>
            <a:rPr lang="en-GB" sz="1300" dirty="0"/>
            <a:t>Clinical outcomes</a:t>
          </a:r>
        </a:p>
      </dgm:t>
    </dgm:pt>
    <dgm:pt modelId="{62C73D36-5312-4420-ABCF-A90575E8BF2C}" type="parTrans" cxnId="{99D4A9A4-20CB-41DC-9760-94DBF40D16C2}">
      <dgm:prSet/>
      <dgm:spPr/>
      <dgm:t>
        <a:bodyPr/>
        <a:lstStyle/>
        <a:p>
          <a:endParaRPr lang="en-US"/>
        </a:p>
      </dgm:t>
    </dgm:pt>
    <dgm:pt modelId="{0B49C5EA-E219-493D-8106-95B589664502}" type="sibTrans" cxnId="{99D4A9A4-20CB-41DC-9760-94DBF40D16C2}">
      <dgm:prSet/>
      <dgm:spPr/>
      <dgm:t>
        <a:bodyPr/>
        <a:lstStyle/>
        <a:p>
          <a:endParaRPr lang="en-US"/>
        </a:p>
      </dgm:t>
    </dgm:pt>
    <dgm:pt modelId="{8FDBF81E-7704-4600-94B7-A32AFF945967}">
      <dgm:prSet phldrT="[Text]" custT="1"/>
      <dgm:spPr/>
      <dgm:t>
        <a:bodyPr/>
        <a:lstStyle/>
        <a:p>
          <a:r>
            <a:rPr lang="en-GB" sz="1300" dirty="0"/>
            <a:t>Responses to AHA Cholesterol Care Plan </a:t>
          </a:r>
          <a:r>
            <a:rPr lang="en-GB" sz="1300" dirty="0" smtClean="0"/>
            <a:t>&amp; additional </a:t>
          </a:r>
          <a:r>
            <a:rPr lang="en-GB" sz="1300" dirty="0" smtClean="0"/>
            <a:t>Web </a:t>
          </a:r>
          <a:r>
            <a:rPr lang="en-GB" sz="1300" dirty="0" smtClean="0"/>
            <a:t>app ?s</a:t>
          </a:r>
          <a:endParaRPr lang="en-GB" sz="1300" dirty="0"/>
        </a:p>
      </dgm:t>
    </dgm:pt>
    <dgm:pt modelId="{B64FA5AD-5EAA-40BF-BE1B-8EFBC571B1C1}" type="parTrans" cxnId="{82C799FD-4477-4E1C-BA0F-E8BC8A26C2FE}">
      <dgm:prSet/>
      <dgm:spPr/>
      <dgm:t>
        <a:bodyPr/>
        <a:lstStyle/>
        <a:p>
          <a:endParaRPr lang="en-US"/>
        </a:p>
      </dgm:t>
    </dgm:pt>
    <dgm:pt modelId="{1866850B-52ED-4FF6-8364-8B4310092B1C}" type="sibTrans" cxnId="{82C799FD-4477-4E1C-BA0F-E8BC8A26C2FE}">
      <dgm:prSet/>
      <dgm:spPr/>
      <dgm:t>
        <a:bodyPr/>
        <a:lstStyle/>
        <a:p>
          <a:endParaRPr lang="en-US"/>
        </a:p>
      </dgm:t>
    </dgm:pt>
    <dgm:pt modelId="{5B98C464-18CE-43A6-9892-B6CEE42532A3}">
      <dgm:prSet custT="1"/>
      <dgm:spPr/>
      <dgm:t>
        <a:bodyPr/>
        <a:lstStyle/>
        <a:p>
          <a:r>
            <a:rPr lang="en-GB" sz="1300" dirty="0"/>
            <a:t>Clinical outcomes</a:t>
          </a:r>
        </a:p>
      </dgm:t>
    </dgm:pt>
    <dgm:pt modelId="{5FC929C9-43DD-4B77-8237-4FAD56DC77B6}" type="parTrans" cxnId="{430EC0D6-0D46-4A1B-BBB5-1FAAB7CC8BAC}">
      <dgm:prSet/>
      <dgm:spPr/>
      <dgm:t>
        <a:bodyPr/>
        <a:lstStyle/>
        <a:p>
          <a:endParaRPr lang="en-US"/>
        </a:p>
      </dgm:t>
    </dgm:pt>
    <dgm:pt modelId="{5F36C2A3-6974-4ECA-AECF-83D4A6D74285}" type="sibTrans" cxnId="{430EC0D6-0D46-4A1B-BBB5-1FAAB7CC8BAC}">
      <dgm:prSet/>
      <dgm:spPr/>
      <dgm:t>
        <a:bodyPr/>
        <a:lstStyle/>
        <a:p>
          <a:endParaRPr lang="en-US"/>
        </a:p>
      </dgm:t>
    </dgm:pt>
    <dgm:pt modelId="{0868E835-98D5-4F9A-AEDD-9408AE9863E6}">
      <dgm:prSet custT="1"/>
      <dgm:spPr/>
      <dgm:t>
        <a:bodyPr/>
        <a:lstStyle/>
        <a:p>
          <a:r>
            <a:rPr lang="en-GB" sz="1300" dirty="0"/>
            <a:t>Clinical outcomes</a:t>
          </a:r>
        </a:p>
      </dgm:t>
    </dgm:pt>
    <dgm:pt modelId="{D96AB76C-20D5-4750-A461-E1A97F7DFD94}" type="parTrans" cxnId="{8EB0466E-CB10-4F99-B9FA-7520DECD443C}">
      <dgm:prSet/>
      <dgm:spPr/>
      <dgm:t>
        <a:bodyPr/>
        <a:lstStyle/>
        <a:p>
          <a:endParaRPr lang="en-US"/>
        </a:p>
      </dgm:t>
    </dgm:pt>
    <dgm:pt modelId="{A649F6F8-4A0B-41D9-830E-39F8ED3D4CF2}" type="sibTrans" cxnId="{8EB0466E-CB10-4F99-B9FA-7520DECD443C}">
      <dgm:prSet/>
      <dgm:spPr/>
      <dgm:t>
        <a:bodyPr/>
        <a:lstStyle/>
        <a:p>
          <a:endParaRPr lang="en-US"/>
        </a:p>
      </dgm:t>
    </dgm:pt>
    <dgm:pt modelId="{6C886445-A14C-4880-9FEA-585A11044EB6}">
      <dgm:prSet custT="1"/>
      <dgm:spPr/>
      <dgm:t>
        <a:bodyPr/>
        <a:lstStyle/>
        <a:p>
          <a:r>
            <a:rPr lang="en-GB" sz="1300" dirty="0"/>
            <a:t>Responses to AHA Cholesterol Care Plan </a:t>
          </a:r>
          <a:r>
            <a:rPr lang="en-GB" sz="1300" dirty="0" smtClean="0"/>
            <a:t>&amp; additional </a:t>
          </a:r>
          <a:r>
            <a:rPr lang="en-GB" sz="1300" dirty="0" smtClean="0"/>
            <a:t>Web </a:t>
          </a:r>
          <a:r>
            <a:rPr lang="en-GB" sz="1300" dirty="0" smtClean="0"/>
            <a:t>app ?s</a:t>
          </a:r>
          <a:endParaRPr lang="en-GB" sz="1300" dirty="0"/>
        </a:p>
      </dgm:t>
    </dgm:pt>
    <dgm:pt modelId="{606E988E-7099-4702-9FB9-3A6513F2DA3E}" type="parTrans" cxnId="{7BF035AB-1105-48C3-84DE-BF0C68597840}">
      <dgm:prSet/>
      <dgm:spPr/>
      <dgm:t>
        <a:bodyPr/>
        <a:lstStyle/>
        <a:p>
          <a:endParaRPr lang="en-US"/>
        </a:p>
      </dgm:t>
    </dgm:pt>
    <dgm:pt modelId="{CC6C88D4-A033-4333-808F-57C894726AEB}" type="sibTrans" cxnId="{7BF035AB-1105-48C3-84DE-BF0C68597840}">
      <dgm:prSet/>
      <dgm:spPr/>
      <dgm:t>
        <a:bodyPr/>
        <a:lstStyle/>
        <a:p>
          <a:endParaRPr lang="en-US"/>
        </a:p>
      </dgm:t>
    </dgm:pt>
    <dgm:pt modelId="{F123C44F-6DE8-46E4-80F1-4E45A38E5098}">
      <dgm:prSet custT="1"/>
      <dgm:spPr/>
      <dgm:t>
        <a:bodyPr/>
        <a:lstStyle/>
        <a:p>
          <a:r>
            <a:rPr lang="en-GB" sz="1300" dirty="0"/>
            <a:t>D.O.B.</a:t>
          </a:r>
        </a:p>
      </dgm:t>
    </dgm:pt>
    <dgm:pt modelId="{73160DA4-A549-40A7-8026-1A4A3CBD6AC2}" type="parTrans" cxnId="{5D6D8835-50F4-4ADB-AC71-AD30F94F98A0}">
      <dgm:prSet/>
      <dgm:spPr/>
      <dgm:t>
        <a:bodyPr/>
        <a:lstStyle/>
        <a:p>
          <a:endParaRPr lang="en-US"/>
        </a:p>
      </dgm:t>
    </dgm:pt>
    <dgm:pt modelId="{FDA66D61-4808-4EF2-846E-230BB4C96BE9}" type="sibTrans" cxnId="{5D6D8835-50F4-4ADB-AC71-AD30F94F98A0}">
      <dgm:prSet/>
      <dgm:spPr/>
      <dgm:t>
        <a:bodyPr/>
        <a:lstStyle/>
        <a:p>
          <a:endParaRPr lang="en-US"/>
        </a:p>
      </dgm:t>
    </dgm:pt>
    <dgm:pt modelId="{C08466BF-65C3-403C-8983-9938379712B4}">
      <dgm:prSet custT="1"/>
      <dgm:spPr/>
      <dgm:t>
        <a:bodyPr/>
        <a:lstStyle/>
        <a:p>
          <a:r>
            <a:rPr lang="en-GB" sz="1300" dirty="0"/>
            <a:t>Responses to AHA Cholesterol Care Plan </a:t>
          </a:r>
          <a:r>
            <a:rPr lang="en-GB" sz="1300" dirty="0" smtClean="0"/>
            <a:t>&amp; additional </a:t>
          </a:r>
          <a:r>
            <a:rPr lang="en-GB" sz="1300" dirty="0" smtClean="0"/>
            <a:t>Web </a:t>
          </a:r>
          <a:r>
            <a:rPr lang="en-GB" sz="1300" dirty="0" smtClean="0"/>
            <a:t>app ?s</a:t>
          </a:r>
          <a:endParaRPr lang="en-GB" sz="1300" dirty="0"/>
        </a:p>
      </dgm:t>
    </dgm:pt>
    <dgm:pt modelId="{ABD90EC8-DC63-4CF1-94CE-5B0DF286BDF6}" type="parTrans" cxnId="{4339EA31-70B3-4735-BE45-5780C2FCC3FD}">
      <dgm:prSet/>
      <dgm:spPr/>
      <dgm:t>
        <a:bodyPr/>
        <a:lstStyle/>
        <a:p>
          <a:endParaRPr lang="en-US"/>
        </a:p>
      </dgm:t>
    </dgm:pt>
    <dgm:pt modelId="{2B2D13E0-ECDE-4666-9036-D293A1460FD0}" type="sibTrans" cxnId="{4339EA31-70B3-4735-BE45-5780C2FCC3FD}">
      <dgm:prSet/>
      <dgm:spPr/>
      <dgm:t>
        <a:bodyPr/>
        <a:lstStyle/>
        <a:p>
          <a:endParaRPr lang="en-US"/>
        </a:p>
      </dgm:t>
    </dgm:pt>
    <dgm:pt modelId="{B7536E49-AC7F-405D-827A-8AB8E2F69DFF}">
      <dgm:prSet custT="1"/>
      <dgm:spPr/>
      <dgm:t>
        <a:bodyPr/>
        <a:lstStyle/>
        <a:p>
          <a:r>
            <a:rPr lang="en-GB" sz="1300" dirty="0"/>
            <a:t>Patient Consent Form</a:t>
          </a:r>
        </a:p>
      </dgm:t>
    </dgm:pt>
    <dgm:pt modelId="{2F163A08-2E26-4DBE-B6DC-022560635425}" type="parTrans" cxnId="{1F18716D-A82B-480D-B6AC-E3F467B9D02B}">
      <dgm:prSet/>
      <dgm:spPr/>
      <dgm:t>
        <a:bodyPr/>
        <a:lstStyle/>
        <a:p>
          <a:endParaRPr lang="en-US"/>
        </a:p>
      </dgm:t>
    </dgm:pt>
    <dgm:pt modelId="{89F66963-9EA0-4A95-9B50-D6E3576EE9A1}" type="sibTrans" cxnId="{1F18716D-A82B-480D-B6AC-E3F467B9D02B}">
      <dgm:prSet/>
      <dgm:spPr/>
      <dgm:t>
        <a:bodyPr/>
        <a:lstStyle/>
        <a:p>
          <a:endParaRPr lang="en-US"/>
        </a:p>
      </dgm:t>
    </dgm:pt>
    <dgm:pt modelId="{DDB4539C-42BD-483C-B354-AD3972DB1830}" type="pres">
      <dgm:prSet presAssocID="{834A4D0A-7B4F-4359-BA93-2C13BF74EDA0}" presName="theList" presStyleCnt="0">
        <dgm:presLayoutVars>
          <dgm:dir/>
          <dgm:animLvl val="lvl"/>
          <dgm:resizeHandles val="exact"/>
        </dgm:presLayoutVars>
      </dgm:prSet>
      <dgm:spPr/>
      <dgm:t>
        <a:bodyPr/>
        <a:lstStyle/>
        <a:p>
          <a:endParaRPr lang="en-GB"/>
        </a:p>
      </dgm:t>
    </dgm:pt>
    <dgm:pt modelId="{D2196A4D-F295-4B49-B2D3-7B36ADB1D0C8}" type="pres">
      <dgm:prSet presAssocID="{B20DE993-EC76-4012-921D-37ACF96121B2}" presName="compNode" presStyleCnt="0"/>
      <dgm:spPr/>
    </dgm:pt>
    <dgm:pt modelId="{D4DEFC61-50E1-4863-810B-725548DCAEF1}" type="pres">
      <dgm:prSet presAssocID="{B20DE993-EC76-4012-921D-37ACF96121B2}" presName="noGeometry" presStyleCnt="0"/>
      <dgm:spPr/>
    </dgm:pt>
    <dgm:pt modelId="{FD5FE5AF-D80B-4FBB-9606-C1B3398D8AC2}" type="pres">
      <dgm:prSet presAssocID="{B20DE993-EC76-4012-921D-37ACF96121B2}" presName="childTextVisible" presStyleLbl="bgAccFollowNode1" presStyleIdx="0" presStyleCnt="3" custScaleY="121701" custLinFactNeighborX="-9700" custLinFactNeighborY="-10877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674AF7A1-B4E1-45FE-8271-D9779195F5D9}" type="pres">
      <dgm:prSet presAssocID="{B20DE993-EC76-4012-921D-37ACF96121B2}" presName="childTextHidden" presStyleLbl="bgAccFollowNode1" presStyleIdx="0" presStyleCnt="3"/>
      <dgm:spPr/>
      <dgm:t>
        <a:bodyPr/>
        <a:lstStyle/>
        <a:p>
          <a:endParaRPr lang="en-GB"/>
        </a:p>
      </dgm:t>
    </dgm:pt>
    <dgm:pt modelId="{AE8C43CD-72A9-4611-AAA1-7A65254F2684}" type="pres">
      <dgm:prSet presAssocID="{B20DE993-EC76-4012-921D-37ACF96121B2}" presName="parentText" presStyleLbl="node1" presStyleIdx="0" presStyleCnt="3" custScaleX="82816" custScaleY="79066" custLinFactNeighborX="-9941" custLinFactNeighborY="-19005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B2582866-5DCA-496D-9BCF-C16385E842E5}" type="pres">
      <dgm:prSet presAssocID="{B20DE993-EC76-4012-921D-37ACF96121B2}" presName="aSpace" presStyleCnt="0"/>
      <dgm:spPr/>
    </dgm:pt>
    <dgm:pt modelId="{59E6896B-4A7C-4074-857B-45A9D4F0F68A}" type="pres">
      <dgm:prSet presAssocID="{5150DBBA-A014-48FD-9CA4-07146E30F64D}" presName="compNode" presStyleCnt="0"/>
      <dgm:spPr/>
    </dgm:pt>
    <dgm:pt modelId="{08FA1EAD-C649-432A-8CA4-5A04CA1B0426}" type="pres">
      <dgm:prSet presAssocID="{5150DBBA-A014-48FD-9CA4-07146E30F64D}" presName="noGeometry" presStyleCnt="0"/>
      <dgm:spPr/>
    </dgm:pt>
    <dgm:pt modelId="{DB921617-3D76-43EA-9080-A6928D957AC0}" type="pres">
      <dgm:prSet presAssocID="{5150DBBA-A014-48FD-9CA4-07146E30F64D}" presName="childTextVisible" presStyleLbl="bgAccFollowNode1" presStyleIdx="1" presStyleCnt="3" custScaleY="79005" custLinFactNeighborX="-19640" custLinFactNeighborY="-9683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9D50B4D5-67A0-4F7B-8A36-7FED3A0BADCD}" type="pres">
      <dgm:prSet presAssocID="{5150DBBA-A014-48FD-9CA4-07146E30F64D}" presName="childTextHidden" presStyleLbl="bgAccFollowNode1" presStyleIdx="1" presStyleCnt="3"/>
      <dgm:spPr/>
      <dgm:t>
        <a:bodyPr/>
        <a:lstStyle/>
        <a:p>
          <a:endParaRPr lang="en-GB"/>
        </a:p>
      </dgm:t>
    </dgm:pt>
    <dgm:pt modelId="{DB9C4CDC-829A-4D3A-836C-CB22248CED44}" type="pres">
      <dgm:prSet presAssocID="{5150DBBA-A014-48FD-9CA4-07146E30F64D}" presName="parentText" presStyleLbl="node1" presStyleIdx="1" presStyleCnt="3" custScaleX="88013" custScaleY="80539" custLinFactNeighborX="-35733" custLinFactNeighborY="-20810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A33C1EFC-4304-4BE8-9838-50B03682242F}" type="pres">
      <dgm:prSet presAssocID="{5150DBBA-A014-48FD-9CA4-07146E30F64D}" presName="aSpace" presStyleCnt="0"/>
      <dgm:spPr/>
    </dgm:pt>
    <dgm:pt modelId="{10A02346-F88F-43BF-89F9-F2E597165644}" type="pres">
      <dgm:prSet presAssocID="{31FBC1D5-391B-444B-B524-94E917D06623}" presName="compNode" presStyleCnt="0"/>
      <dgm:spPr/>
    </dgm:pt>
    <dgm:pt modelId="{FC1DD737-B969-4F9D-9752-AA1BCF340654}" type="pres">
      <dgm:prSet presAssocID="{31FBC1D5-391B-444B-B524-94E917D06623}" presName="noGeometry" presStyleCnt="0"/>
      <dgm:spPr/>
    </dgm:pt>
    <dgm:pt modelId="{AAAB698C-F27B-44AE-89C0-200949C3E0BF}" type="pres">
      <dgm:prSet presAssocID="{31FBC1D5-391B-444B-B524-94E917D06623}" presName="childTextVisible" presStyleLbl="bgAccFollowNode1" presStyleIdx="2" presStyleCnt="3" custScaleY="125040" custLinFactNeighborX="-28367" custLinFactNeighborY="-5037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9F3692B1-8F48-42C6-85DF-6227852D481E}" type="pres">
      <dgm:prSet presAssocID="{31FBC1D5-391B-444B-B524-94E917D06623}" presName="childTextHidden" presStyleLbl="bgAccFollowNode1" presStyleIdx="2" presStyleCnt="3"/>
      <dgm:spPr/>
      <dgm:t>
        <a:bodyPr/>
        <a:lstStyle/>
        <a:p>
          <a:endParaRPr lang="en-GB"/>
        </a:p>
      </dgm:t>
    </dgm:pt>
    <dgm:pt modelId="{651066C6-62ED-4D8C-AE28-B19E8DDBBC20}" type="pres">
      <dgm:prSet presAssocID="{31FBC1D5-391B-444B-B524-94E917D06623}" presName="parentText" presStyleLbl="node1" presStyleIdx="2" presStyleCnt="3" custScaleX="91055" custScaleY="74261" custLinFactNeighborX="-55359" custLinFactNeighborY="-17497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</dgm:ptLst>
  <dgm:cxnLst>
    <dgm:cxn modelId="{ED324516-F2E9-4417-9799-B032601B1BDE}" type="presOf" srcId="{B7536E49-AC7F-405D-827A-8AB8E2F69DFF}" destId="{9F3692B1-8F48-42C6-85DF-6227852D481E}" srcOrd="1" destOrd="4" presId="urn:microsoft.com/office/officeart/2005/8/layout/hProcess6"/>
    <dgm:cxn modelId="{51996E93-5F47-4813-B66F-D63106E05473}" type="presOf" srcId="{5B98C464-18CE-43A6-9892-B6CEE42532A3}" destId="{AAAB698C-F27B-44AE-89C0-200949C3E0BF}" srcOrd="0" destOrd="2" presId="urn:microsoft.com/office/officeart/2005/8/layout/hProcess6"/>
    <dgm:cxn modelId="{3EFDB014-1CE6-4BB9-9685-6BFE917184B3}" type="presOf" srcId="{5150DBBA-A014-48FD-9CA4-07146E30F64D}" destId="{DB9C4CDC-829A-4D3A-836C-CB22248CED44}" srcOrd="0" destOrd="0" presId="urn:microsoft.com/office/officeart/2005/8/layout/hProcess6"/>
    <dgm:cxn modelId="{F487ED0E-7BEA-4827-AC87-A8FE45E47336}" type="presOf" srcId="{D4496064-C95D-4831-8F40-824C439FBF33}" destId="{674AF7A1-B4E1-45FE-8271-D9779195F5D9}" srcOrd="1" destOrd="1" presId="urn:microsoft.com/office/officeart/2005/8/layout/hProcess6"/>
    <dgm:cxn modelId="{10F307D6-B208-4C7D-962D-3CEACF152D3B}" type="presOf" srcId="{2E4CFC3E-1DC3-431E-9CD7-BE4BF56F5B26}" destId="{9D50B4D5-67A0-4F7B-8A36-7FED3A0BADCD}" srcOrd="1" destOrd="0" presId="urn:microsoft.com/office/officeart/2005/8/layout/hProcess6"/>
    <dgm:cxn modelId="{2C0DDB8A-5159-4638-A132-4CCB2119234A}" srcId="{834A4D0A-7B4F-4359-BA93-2C13BF74EDA0}" destId="{5150DBBA-A014-48FD-9CA4-07146E30F64D}" srcOrd="1" destOrd="0" parTransId="{DA971BFC-0D7A-4DE0-BDB8-E0F9EE4474A6}" sibTransId="{43A8421F-1BA2-4BC0-9E74-DC3E843731A4}"/>
    <dgm:cxn modelId="{9BD30486-1386-4346-9CD9-549BA9986B59}" type="presOf" srcId="{30C81DDA-E18E-4795-B88F-09B2347590A6}" destId="{FD5FE5AF-D80B-4FBB-9606-C1B3398D8AC2}" srcOrd="0" destOrd="2" presId="urn:microsoft.com/office/officeart/2005/8/layout/hProcess6"/>
    <dgm:cxn modelId="{8000C399-1EAF-4756-A735-61F7DAD29F88}" type="presOf" srcId="{39955DF2-2E4B-45FB-ADC2-5CAF6E5F4AB0}" destId="{674AF7A1-B4E1-45FE-8271-D9779195F5D9}" srcOrd="1" destOrd="7" presId="urn:microsoft.com/office/officeart/2005/8/layout/hProcess6"/>
    <dgm:cxn modelId="{1F18716D-A82B-480D-B6AC-E3F467B9D02B}" srcId="{31FBC1D5-391B-444B-B524-94E917D06623}" destId="{B7536E49-AC7F-405D-827A-8AB8E2F69DFF}" srcOrd="4" destOrd="0" parTransId="{2F163A08-2E26-4DBE-B6DC-022560635425}" sibTransId="{89F66963-9EA0-4A95-9B50-D6E3576EE9A1}"/>
    <dgm:cxn modelId="{6B7A4875-3B91-4DFD-8A0A-03B55BCBD374}" type="presOf" srcId="{C08466BF-65C3-403C-8983-9938379712B4}" destId="{AAAB698C-F27B-44AE-89C0-200949C3E0BF}" srcOrd="0" destOrd="3" presId="urn:microsoft.com/office/officeart/2005/8/layout/hProcess6"/>
    <dgm:cxn modelId="{430EC0D6-0D46-4A1B-BBB5-1FAAB7CC8BAC}" srcId="{31FBC1D5-391B-444B-B524-94E917D06623}" destId="{5B98C464-18CE-43A6-9892-B6CEE42532A3}" srcOrd="2" destOrd="0" parTransId="{5FC929C9-43DD-4B77-8237-4FAD56DC77B6}" sibTransId="{5F36C2A3-6974-4ECA-AECF-83D4A6D74285}"/>
    <dgm:cxn modelId="{255A8768-3300-4434-BA4E-E68C2E958E5F}" type="presOf" srcId="{5B98C464-18CE-43A6-9892-B6CEE42532A3}" destId="{9F3692B1-8F48-42C6-85DF-6227852D481E}" srcOrd="1" destOrd="2" presId="urn:microsoft.com/office/officeart/2005/8/layout/hProcess6"/>
    <dgm:cxn modelId="{92198AB3-508A-442B-84A1-72AEB26E8335}" type="presOf" srcId="{8FDBF81E-7704-4600-94B7-A32AFF945967}" destId="{DB921617-3D76-43EA-9080-A6928D957AC0}" srcOrd="0" destOrd="2" presId="urn:microsoft.com/office/officeart/2005/8/layout/hProcess6"/>
    <dgm:cxn modelId="{4455B13C-2F90-4B09-B988-DC3B0F2CEAA1}" type="presOf" srcId="{7E15A40E-EB63-4F19-9FB6-8BC8EAB63B7A}" destId="{9F3692B1-8F48-42C6-85DF-6227852D481E}" srcOrd="1" destOrd="0" presId="urn:microsoft.com/office/officeart/2005/8/layout/hProcess6"/>
    <dgm:cxn modelId="{0654B708-CAEF-4F37-9A0F-D657D7BC531B}" type="presOf" srcId="{B7536E49-AC7F-405D-827A-8AB8E2F69DFF}" destId="{AAAB698C-F27B-44AE-89C0-200949C3E0BF}" srcOrd="0" destOrd="4" presId="urn:microsoft.com/office/officeart/2005/8/layout/hProcess6"/>
    <dgm:cxn modelId="{99D4A9A4-20CB-41DC-9760-94DBF40D16C2}" srcId="{5150DBBA-A014-48FD-9CA4-07146E30F64D}" destId="{46C1AEE6-768F-4176-BE10-A23DB5BE1D2B}" srcOrd="1" destOrd="0" parTransId="{62C73D36-5312-4420-ABCF-A90575E8BF2C}" sibTransId="{0B49C5EA-E219-493D-8106-95B589664502}"/>
    <dgm:cxn modelId="{81E48EC4-6CDD-4C28-8859-BCB512ED56A9}" type="presOf" srcId="{57F6C132-9116-47D5-B649-218BFE557B40}" destId="{AAAB698C-F27B-44AE-89C0-200949C3E0BF}" srcOrd="0" destOrd="1" presId="urn:microsoft.com/office/officeart/2005/8/layout/hProcess6"/>
    <dgm:cxn modelId="{0813B293-3492-4CBB-8144-D773F0071AD1}" type="presOf" srcId="{8FDBF81E-7704-4600-94B7-A32AFF945967}" destId="{9D50B4D5-67A0-4F7B-8A36-7FED3A0BADCD}" srcOrd="1" destOrd="2" presId="urn:microsoft.com/office/officeart/2005/8/layout/hProcess6"/>
    <dgm:cxn modelId="{F789AC63-E290-46F6-8097-CF325151B10C}" type="presOf" srcId="{F123C44F-6DE8-46E4-80F1-4E45A38E5098}" destId="{FD5FE5AF-D80B-4FBB-9606-C1B3398D8AC2}" srcOrd="0" destOrd="4" presId="urn:microsoft.com/office/officeart/2005/8/layout/hProcess6"/>
    <dgm:cxn modelId="{4339EA31-70B3-4735-BE45-5780C2FCC3FD}" srcId="{31FBC1D5-391B-444B-B524-94E917D06623}" destId="{C08466BF-65C3-403C-8983-9938379712B4}" srcOrd="3" destOrd="0" parTransId="{ABD90EC8-DC63-4CF1-94CE-5B0DF286BDF6}" sibTransId="{2B2D13E0-ECDE-4666-9036-D293A1460FD0}"/>
    <dgm:cxn modelId="{BACE7665-94B3-4434-8275-260817F953E0}" type="presOf" srcId="{6C886445-A14C-4880-9FEA-585A11044EB6}" destId="{674AF7A1-B4E1-45FE-8271-D9779195F5D9}" srcOrd="1" destOrd="6" presId="urn:microsoft.com/office/officeart/2005/8/layout/hProcess6"/>
    <dgm:cxn modelId="{7C22E374-8CCF-406D-967A-5245128CB9D8}" type="presOf" srcId="{D4496064-C95D-4831-8F40-824C439FBF33}" destId="{FD5FE5AF-D80B-4FBB-9606-C1B3398D8AC2}" srcOrd="0" destOrd="1" presId="urn:microsoft.com/office/officeart/2005/8/layout/hProcess6"/>
    <dgm:cxn modelId="{14C7BF01-B892-4601-A2C9-91EC9FB33D37}" srcId="{B20DE993-EC76-4012-921D-37ACF96121B2}" destId="{07DE7DBE-459C-488B-921C-1798FD60EA0B}" srcOrd="0" destOrd="0" parTransId="{B1C441C3-C458-41F7-AC39-47F9F3054A17}" sibTransId="{382AB4E6-9B94-47B8-88F7-7FB05D9E6319}"/>
    <dgm:cxn modelId="{88CAF33A-49BF-42FF-8B0B-97F371958405}" type="presOf" srcId="{834A4D0A-7B4F-4359-BA93-2C13BF74EDA0}" destId="{DDB4539C-42BD-483C-B354-AD3972DB1830}" srcOrd="0" destOrd="0" presId="urn:microsoft.com/office/officeart/2005/8/layout/hProcess6"/>
    <dgm:cxn modelId="{1271BAF9-E4C2-4B7F-A835-3BCA0321F6EB}" type="presOf" srcId="{2E4CFC3E-1DC3-431E-9CD7-BE4BF56F5B26}" destId="{DB921617-3D76-43EA-9080-A6928D957AC0}" srcOrd="0" destOrd="0" presId="urn:microsoft.com/office/officeart/2005/8/layout/hProcess6"/>
    <dgm:cxn modelId="{7BF035AB-1105-48C3-84DE-BF0C68597840}" srcId="{B20DE993-EC76-4012-921D-37ACF96121B2}" destId="{6C886445-A14C-4880-9FEA-585A11044EB6}" srcOrd="6" destOrd="0" parTransId="{606E988E-7099-4702-9FB9-3A6513F2DA3E}" sibTransId="{CC6C88D4-A033-4333-808F-57C894726AEB}"/>
    <dgm:cxn modelId="{44873E73-473F-462D-9510-EF2536DEF51F}" type="presOf" srcId="{31FBC1D5-391B-444B-B524-94E917D06623}" destId="{651066C6-62ED-4D8C-AE28-B19E8DDBBC20}" srcOrd="0" destOrd="0" presId="urn:microsoft.com/office/officeart/2005/8/layout/hProcess6"/>
    <dgm:cxn modelId="{10B8E0AD-78D3-40A5-A4D5-D2EFFC7601BE}" type="presOf" srcId="{0868E835-98D5-4F9A-AEDD-9408AE9863E6}" destId="{FD5FE5AF-D80B-4FBB-9606-C1B3398D8AC2}" srcOrd="0" destOrd="5" presId="urn:microsoft.com/office/officeart/2005/8/layout/hProcess6"/>
    <dgm:cxn modelId="{0B361C4D-EA01-4243-A76F-67E4D254019A}" srcId="{834A4D0A-7B4F-4359-BA93-2C13BF74EDA0}" destId="{31FBC1D5-391B-444B-B524-94E917D06623}" srcOrd="2" destOrd="0" parTransId="{7864CD3C-CE53-4E32-BD2C-4C96558ABF97}" sibTransId="{BB37BEB6-10FF-4092-B45C-1D58BC0E6A57}"/>
    <dgm:cxn modelId="{38A10E6E-4538-4E10-8500-0B21A31E76C6}" srcId="{31FBC1D5-391B-444B-B524-94E917D06623}" destId="{57F6C132-9116-47D5-B649-218BFE557B40}" srcOrd="1" destOrd="0" parTransId="{1713CB1F-2096-465B-BAC3-62CF4F341950}" sibTransId="{58C7C361-799C-4E35-B0AD-6307CD23FA27}"/>
    <dgm:cxn modelId="{8EB0466E-CB10-4F99-B9FA-7520DECD443C}" srcId="{B20DE993-EC76-4012-921D-37ACF96121B2}" destId="{0868E835-98D5-4F9A-AEDD-9408AE9863E6}" srcOrd="5" destOrd="0" parTransId="{D96AB76C-20D5-4750-A461-E1A97F7DFD94}" sibTransId="{A649F6F8-4A0B-41D9-830E-39F8ED3D4CF2}"/>
    <dgm:cxn modelId="{81664248-C875-47B3-A89E-A7177EEA9440}" type="presOf" srcId="{46C1AEE6-768F-4176-BE10-A23DB5BE1D2B}" destId="{9D50B4D5-67A0-4F7B-8A36-7FED3A0BADCD}" srcOrd="1" destOrd="1" presId="urn:microsoft.com/office/officeart/2005/8/layout/hProcess6"/>
    <dgm:cxn modelId="{93A8FA1D-5D79-4ED6-AD8E-43ADB8893D4B}" srcId="{B20DE993-EC76-4012-921D-37ACF96121B2}" destId="{39955DF2-2E4B-45FB-ADC2-5CAF6E5F4AB0}" srcOrd="7" destOrd="0" parTransId="{B22DEC13-D4A3-43AC-A48D-BB57EF54B77B}" sibTransId="{C88461C2-401D-4217-866A-99764488615D}"/>
    <dgm:cxn modelId="{31064EF3-6143-4BA2-846C-E31A1E126CEB}" srcId="{31FBC1D5-391B-444B-B524-94E917D06623}" destId="{7E15A40E-EB63-4F19-9FB6-8BC8EAB63B7A}" srcOrd="0" destOrd="0" parTransId="{E773C87C-F0B9-4922-85D5-B701A31C0C8A}" sibTransId="{EA7471FC-5D26-49CE-95D8-A567D819342F}"/>
    <dgm:cxn modelId="{53501D66-06ED-4F92-9A10-A3CC056C6B12}" type="presOf" srcId="{39955DF2-2E4B-45FB-ADC2-5CAF6E5F4AB0}" destId="{FD5FE5AF-D80B-4FBB-9606-C1B3398D8AC2}" srcOrd="0" destOrd="7" presId="urn:microsoft.com/office/officeart/2005/8/layout/hProcess6"/>
    <dgm:cxn modelId="{43F7FE0C-BE72-4211-B47B-06DB88ABB51F}" srcId="{B20DE993-EC76-4012-921D-37ACF96121B2}" destId="{30C81DDA-E18E-4795-B88F-09B2347590A6}" srcOrd="2" destOrd="0" parTransId="{AB5A7CF9-78E5-4395-BCAA-D265E7FA43E5}" sibTransId="{1C99A81A-CB71-4FD8-AA02-4E58BA2D5779}"/>
    <dgm:cxn modelId="{5F8FF4CD-1795-41DA-A757-A5DAEBA7312E}" type="presOf" srcId="{7E15A40E-EB63-4F19-9FB6-8BC8EAB63B7A}" destId="{AAAB698C-F27B-44AE-89C0-200949C3E0BF}" srcOrd="0" destOrd="0" presId="urn:microsoft.com/office/officeart/2005/8/layout/hProcess6"/>
    <dgm:cxn modelId="{6D0DBEA1-50AF-44F5-9AFB-791F379BB9C3}" type="presOf" srcId="{0868E835-98D5-4F9A-AEDD-9408AE9863E6}" destId="{674AF7A1-B4E1-45FE-8271-D9779195F5D9}" srcOrd="1" destOrd="5" presId="urn:microsoft.com/office/officeart/2005/8/layout/hProcess6"/>
    <dgm:cxn modelId="{52285C53-D490-4476-BDFC-825228EDAA2F}" srcId="{834A4D0A-7B4F-4359-BA93-2C13BF74EDA0}" destId="{B20DE993-EC76-4012-921D-37ACF96121B2}" srcOrd="0" destOrd="0" parTransId="{840D9F93-76D3-4E61-A557-A3FC019B4CFC}" sibTransId="{13E580C5-B282-40FF-A8D6-DEB9A487222B}"/>
    <dgm:cxn modelId="{3380E53F-0A98-416B-A49C-8B2A2EA018F6}" type="presOf" srcId="{6C886445-A14C-4880-9FEA-585A11044EB6}" destId="{FD5FE5AF-D80B-4FBB-9606-C1B3398D8AC2}" srcOrd="0" destOrd="6" presId="urn:microsoft.com/office/officeart/2005/8/layout/hProcess6"/>
    <dgm:cxn modelId="{B7E7970A-905A-4E80-B79B-C74C6725AFD0}" type="presOf" srcId="{B20DE993-EC76-4012-921D-37ACF96121B2}" destId="{AE8C43CD-72A9-4611-AAA1-7A65254F2684}" srcOrd="0" destOrd="0" presId="urn:microsoft.com/office/officeart/2005/8/layout/hProcess6"/>
    <dgm:cxn modelId="{03693CC0-4C0C-48F3-B2CF-166E055BF018}" srcId="{B20DE993-EC76-4012-921D-37ACF96121B2}" destId="{1918FBF4-E643-4F52-92A3-95107699BE21}" srcOrd="3" destOrd="0" parTransId="{C5A08192-E9EF-42BF-9B89-D96BA339ACEB}" sibTransId="{EE8BB1CD-A87B-493D-A76E-230B0391702B}"/>
    <dgm:cxn modelId="{C74996D0-911B-4390-B518-09434FD097BB}" type="presOf" srcId="{46C1AEE6-768F-4176-BE10-A23DB5BE1D2B}" destId="{DB921617-3D76-43EA-9080-A6928D957AC0}" srcOrd="0" destOrd="1" presId="urn:microsoft.com/office/officeart/2005/8/layout/hProcess6"/>
    <dgm:cxn modelId="{82C799FD-4477-4E1C-BA0F-E8BC8A26C2FE}" srcId="{5150DBBA-A014-48FD-9CA4-07146E30F64D}" destId="{8FDBF81E-7704-4600-94B7-A32AFF945967}" srcOrd="2" destOrd="0" parTransId="{B64FA5AD-5EAA-40BF-BE1B-8EFBC571B1C1}" sibTransId="{1866850B-52ED-4FF6-8364-8B4310092B1C}"/>
    <dgm:cxn modelId="{58E4C5E2-84B6-4D91-A7F2-5C2258225E12}" srcId="{5150DBBA-A014-48FD-9CA4-07146E30F64D}" destId="{2E4CFC3E-1DC3-431E-9CD7-BE4BF56F5B26}" srcOrd="0" destOrd="0" parTransId="{A7DC3164-4424-48CC-A256-72614D95F963}" sibTransId="{C58881F9-02A4-4A2D-924A-BEF1361E5DCA}"/>
    <dgm:cxn modelId="{B7672B29-48E6-4B79-B25C-B4DDBA95AA5A}" type="presOf" srcId="{C08466BF-65C3-403C-8983-9938379712B4}" destId="{9F3692B1-8F48-42C6-85DF-6227852D481E}" srcOrd="1" destOrd="3" presId="urn:microsoft.com/office/officeart/2005/8/layout/hProcess6"/>
    <dgm:cxn modelId="{733FF976-F2AF-4FC5-94C7-8CC1C28D5C08}" srcId="{B20DE993-EC76-4012-921D-37ACF96121B2}" destId="{D4496064-C95D-4831-8F40-824C439FBF33}" srcOrd="1" destOrd="0" parTransId="{BED25DF3-7BCB-44E7-81F6-28F8F7A4A93C}" sibTransId="{F74E2329-75C4-42F7-93CC-763C32E36ADD}"/>
    <dgm:cxn modelId="{37273620-49B2-402A-84B0-6DAE79903F84}" type="presOf" srcId="{F123C44F-6DE8-46E4-80F1-4E45A38E5098}" destId="{674AF7A1-B4E1-45FE-8271-D9779195F5D9}" srcOrd="1" destOrd="4" presId="urn:microsoft.com/office/officeart/2005/8/layout/hProcess6"/>
    <dgm:cxn modelId="{A4F0B377-8548-4D1F-B491-A881CBED8B56}" type="presOf" srcId="{07DE7DBE-459C-488B-921C-1798FD60EA0B}" destId="{FD5FE5AF-D80B-4FBB-9606-C1B3398D8AC2}" srcOrd="0" destOrd="0" presId="urn:microsoft.com/office/officeart/2005/8/layout/hProcess6"/>
    <dgm:cxn modelId="{8AABED44-C8EE-473B-B0CD-B035EB228F14}" type="presOf" srcId="{07DE7DBE-459C-488B-921C-1798FD60EA0B}" destId="{674AF7A1-B4E1-45FE-8271-D9779195F5D9}" srcOrd="1" destOrd="0" presId="urn:microsoft.com/office/officeart/2005/8/layout/hProcess6"/>
    <dgm:cxn modelId="{9FCB83F9-7BA1-469B-BEAC-80B87228C195}" type="presOf" srcId="{1918FBF4-E643-4F52-92A3-95107699BE21}" destId="{FD5FE5AF-D80B-4FBB-9606-C1B3398D8AC2}" srcOrd="0" destOrd="3" presId="urn:microsoft.com/office/officeart/2005/8/layout/hProcess6"/>
    <dgm:cxn modelId="{5D6D8835-50F4-4ADB-AC71-AD30F94F98A0}" srcId="{B20DE993-EC76-4012-921D-37ACF96121B2}" destId="{F123C44F-6DE8-46E4-80F1-4E45A38E5098}" srcOrd="4" destOrd="0" parTransId="{73160DA4-A549-40A7-8026-1A4A3CBD6AC2}" sibTransId="{FDA66D61-4808-4EF2-846E-230BB4C96BE9}"/>
    <dgm:cxn modelId="{0A259362-5C77-4402-88FB-CE3E07A5C7C6}" type="presOf" srcId="{57F6C132-9116-47D5-B649-218BFE557B40}" destId="{9F3692B1-8F48-42C6-85DF-6227852D481E}" srcOrd="1" destOrd="1" presId="urn:microsoft.com/office/officeart/2005/8/layout/hProcess6"/>
    <dgm:cxn modelId="{0C6210DB-B509-4791-BBCF-74CFE8E9A192}" type="presOf" srcId="{30C81DDA-E18E-4795-B88F-09B2347590A6}" destId="{674AF7A1-B4E1-45FE-8271-D9779195F5D9}" srcOrd="1" destOrd="2" presId="urn:microsoft.com/office/officeart/2005/8/layout/hProcess6"/>
    <dgm:cxn modelId="{39658B85-4D2E-4B6D-BE21-A097A7F29606}" type="presOf" srcId="{1918FBF4-E643-4F52-92A3-95107699BE21}" destId="{674AF7A1-B4E1-45FE-8271-D9779195F5D9}" srcOrd="1" destOrd="3" presId="urn:microsoft.com/office/officeart/2005/8/layout/hProcess6"/>
    <dgm:cxn modelId="{D6A49D8F-4926-40A8-AAAD-B3A67C255D3B}" type="presParOf" srcId="{DDB4539C-42BD-483C-B354-AD3972DB1830}" destId="{D2196A4D-F295-4B49-B2D3-7B36ADB1D0C8}" srcOrd="0" destOrd="0" presId="urn:microsoft.com/office/officeart/2005/8/layout/hProcess6"/>
    <dgm:cxn modelId="{881BAF88-8813-4CB3-A0E8-CE8EECA91144}" type="presParOf" srcId="{D2196A4D-F295-4B49-B2D3-7B36ADB1D0C8}" destId="{D4DEFC61-50E1-4863-810B-725548DCAEF1}" srcOrd="0" destOrd="0" presId="urn:microsoft.com/office/officeart/2005/8/layout/hProcess6"/>
    <dgm:cxn modelId="{8928EB78-EC94-4A52-9EA1-42666436FBD6}" type="presParOf" srcId="{D2196A4D-F295-4B49-B2D3-7B36ADB1D0C8}" destId="{FD5FE5AF-D80B-4FBB-9606-C1B3398D8AC2}" srcOrd="1" destOrd="0" presId="urn:microsoft.com/office/officeart/2005/8/layout/hProcess6"/>
    <dgm:cxn modelId="{CFD1F868-32B8-4C97-8C5F-C138889565B5}" type="presParOf" srcId="{D2196A4D-F295-4B49-B2D3-7B36ADB1D0C8}" destId="{674AF7A1-B4E1-45FE-8271-D9779195F5D9}" srcOrd="2" destOrd="0" presId="urn:microsoft.com/office/officeart/2005/8/layout/hProcess6"/>
    <dgm:cxn modelId="{60B150B1-9E8F-42AB-90D5-C041DB2E4027}" type="presParOf" srcId="{D2196A4D-F295-4B49-B2D3-7B36ADB1D0C8}" destId="{AE8C43CD-72A9-4611-AAA1-7A65254F2684}" srcOrd="3" destOrd="0" presId="urn:microsoft.com/office/officeart/2005/8/layout/hProcess6"/>
    <dgm:cxn modelId="{FE8FEE36-ADED-49F6-83B4-9DF6030610E0}" type="presParOf" srcId="{DDB4539C-42BD-483C-B354-AD3972DB1830}" destId="{B2582866-5DCA-496D-9BCF-C16385E842E5}" srcOrd="1" destOrd="0" presId="urn:microsoft.com/office/officeart/2005/8/layout/hProcess6"/>
    <dgm:cxn modelId="{F6C17659-4D10-4398-BC09-25046AD2ECD0}" type="presParOf" srcId="{DDB4539C-42BD-483C-B354-AD3972DB1830}" destId="{59E6896B-4A7C-4074-857B-45A9D4F0F68A}" srcOrd="2" destOrd="0" presId="urn:microsoft.com/office/officeart/2005/8/layout/hProcess6"/>
    <dgm:cxn modelId="{37488DC9-B9C2-4BFD-8132-BCD8DC640F58}" type="presParOf" srcId="{59E6896B-4A7C-4074-857B-45A9D4F0F68A}" destId="{08FA1EAD-C649-432A-8CA4-5A04CA1B0426}" srcOrd="0" destOrd="0" presId="urn:microsoft.com/office/officeart/2005/8/layout/hProcess6"/>
    <dgm:cxn modelId="{64413395-2D38-4258-BC5B-E45FAF00ED34}" type="presParOf" srcId="{59E6896B-4A7C-4074-857B-45A9D4F0F68A}" destId="{DB921617-3D76-43EA-9080-A6928D957AC0}" srcOrd="1" destOrd="0" presId="urn:microsoft.com/office/officeart/2005/8/layout/hProcess6"/>
    <dgm:cxn modelId="{0FB63073-DCA0-4037-8A6E-C4422C45B537}" type="presParOf" srcId="{59E6896B-4A7C-4074-857B-45A9D4F0F68A}" destId="{9D50B4D5-67A0-4F7B-8A36-7FED3A0BADCD}" srcOrd="2" destOrd="0" presId="urn:microsoft.com/office/officeart/2005/8/layout/hProcess6"/>
    <dgm:cxn modelId="{9E9ED13B-62AF-4512-A587-68EE88422199}" type="presParOf" srcId="{59E6896B-4A7C-4074-857B-45A9D4F0F68A}" destId="{DB9C4CDC-829A-4D3A-836C-CB22248CED44}" srcOrd="3" destOrd="0" presId="urn:microsoft.com/office/officeart/2005/8/layout/hProcess6"/>
    <dgm:cxn modelId="{C109641C-F7B3-4F8C-BB72-70195696DED5}" type="presParOf" srcId="{DDB4539C-42BD-483C-B354-AD3972DB1830}" destId="{A33C1EFC-4304-4BE8-9838-50B03682242F}" srcOrd="3" destOrd="0" presId="urn:microsoft.com/office/officeart/2005/8/layout/hProcess6"/>
    <dgm:cxn modelId="{A6017585-679D-4684-994D-014964A187B5}" type="presParOf" srcId="{DDB4539C-42BD-483C-B354-AD3972DB1830}" destId="{10A02346-F88F-43BF-89F9-F2E597165644}" srcOrd="4" destOrd="0" presId="urn:microsoft.com/office/officeart/2005/8/layout/hProcess6"/>
    <dgm:cxn modelId="{9AB2721B-3F54-4063-B987-C8F7F4F02096}" type="presParOf" srcId="{10A02346-F88F-43BF-89F9-F2E597165644}" destId="{FC1DD737-B969-4F9D-9752-AA1BCF340654}" srcOrd="0" destOrd="0" presId="urn:microsoft.com/office/officeart/2005/8/layout/hProcess6"/>
    <dgm:cxn modelId="{727A63DD-7AE5-4481-ADE4-A9D623194D98}" type="presParOf" srcId="{10A02346-F88F-43BF-89F9-F2E597165644}" destId="{AAAB698C-F27B-44AE-89C0-200949C3E0BF}" srcOrd="1" destOrd="0" presId="urn:microsoft.com/office/officeart/2005/8/layout/hProcess6"/>
    <dgm:cxn modelId="{CC5E3DF2-1510-46F6-8E33-4749BE0F10A8}" type="presParOf" srcId="{10A02346-F88F-43BF-89F9-F2E597165644}" destId="{9F3692B1-8F48-42C6-85DF-6227852D481E}" srcOrd="2" destOrd="0" presId="urn:microsoft.com/office/officeart/2005/8/layout/hProcess6"/>
    <dgm:cxn modelId="{45C55281-3F7C-46C1-8A2F-520ADCBB6710}" type="presParOf" srcId="{10A02346-F88F-43BF-89F9-F2E597165644}" destId="{651066C6-62ED-4D8C-AE28-B19E8DDBBC20}" srcOrd="3" destOrd="0" presId="urn:microsoft.com/office/officeart/2005/8/layout/hProcess6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FD5FE5AF-D80B-4FBB-9606-C1B3398D8AC2}">
      <dsp:nvSpPr>
        <dsp:cNvPr id="0" name=""/>
        <dsp:cNvSpPr/>
      </dsp:nvSpPr>
      <dsp:spPr>
        <a:xfrm>
          <a:off x="447660" y="1570174"/>
          <a:ext cx="2890111" cy="3074557"/>
        </a:xfrm>
        <a:prstGeom prst="rightArrow">
          <a:avLst>
            <a:gd name="adj1" fmla="val 70000"/>
            <a:gd name="adj2" fmla="val 50000"/>
          </a:avLst>
        </a:prstGeom>
        <a:solidFill>
          <a:schemeClr val="accent2">
            <a:tint val="40000"/>
            <a:alpha val="90000"/>
            <a:hueOff val="0"/>
            <a:satOff val="0"/>
            <a:lumOff val="0"/>
            <a:alphaOff val="0"/>
          </a:schemeClr>
        </a:solidFill>
        <a:ln w="6350" cap="flat" cmpd="sng" algn="ctr">
          <a:solidFill>
            <a:schemeClr val="accent2">
              <a:tint val="40000"/>
              <a:alpha val="9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  <a:scene3d>
          <a:camera prst="orthographicFront"/>
          <a:lightRig rig="flat" dir="t"/>
        </a:scene3d>
        <a:sp3d z="-190500" extrusionH="12700" prstMaterial="plastic">
          <a:bevelT w="50800" h="50800"/>
        </a:sp3d>
      </dsp:spPr>
      <dsp:style>
        <a:lnRef idx="1">
          <a:scrgbClr r="0" g="0" b="0"/>
        </a:lnRef>
        <a:fillRef idx="1">
          <a:scrgbClr r="0" g="0" b="0"/>
        </a:fillRef>
        <a:effectRef idx="2">
          <a:scrgbClr r="0" g="0" b="0"/>
        </a:effectRef>
        <a:fontRef idx="minor"/>
      </dsp:style>
      <dsp:txBody>
        <a:bodyPr spcFirstLastPara="0" vert="horz" wrap="square" lIns="30480" tIns="7620" rIns="15240" bIns="7620" numCol="1" spcCol="1270" anchor="ctr" anchorCtr="0">
          <a:noAutofit/>
        </a:bodyPr>
        <a:lstStyle/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200" kern="1200" dirty="0"/>
        </a:p>
        <a:p>
          <a:pPr marL="114300" lvl="1" indent="-114300" algn="l" defTabSz="5778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300" kern="1200" dirty="0"/>
            <a:t>Unique ID</a:t>
          </a:r>
        </a:p>
        <a:p>
          <a:pPr marL="114300" lvl="1" indent="-114300" algn="l" defTabSz="5778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300" kern="1200" dirty="0"/>
            <a:t>Name</a:t>
          </a:r>
        </a:p>
        <a:p>
          <a:pPr marL="114300" lvl="1" indent="-114300" algn="l" defTabSz="5778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300" kern="1200" dirty="0"/>
            <a:t>Mobile Number</a:t>
          </a:r>
        </a:p>
        <a:p>
          <a:pPr marL="114300" lvl="1" indent="-114300" algn="l" defTabSz="5778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300" kern="1200" dirty="0"/>
            <a:t>D.O.B.</a:t>
          </a:r>
        </a:p>
        <a:p>
          <a:pPr marL="114300" lvl="1" indent="-114300" algn="l" defTabSz="5778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300" kern="1200" dirty="0"/>
            <a:t>Clinical outcomes</a:t>
          </a:r>
        </a:p>
        <a:p>
          <a:pPr marL="114300" lvl="1" indent="-114300" algn="l" defTabSz="5778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300" kern="1200" dirty="0"/>
            <a:t>Responses to AHA Cholesterol Care Plan </a:t>
          </a:r>
          <a:r>
            <a:rPr lang="en-GB" sz="1300" kern="1200" dirty="0" smtClean="0"/>
            <a:t>&amp; additional </a:t>
          </a:r>
          <a:r>
            <a:rPr lang="en-GB" sz="1300" kern="1200" dirty="0" smtClean="0"/>
            <a:t>Web </a:t>
          </a:r>
          <a:r>
            <a:rPr lang="en-GB" sz="1300" kern="1200" dirty="0" smtClean="0"/>
            <a:t>app ?s</a:t>
          </a:r>
          <a:endParaRPr lang="en-GB" sz="1300" kern="1200" dirty="0"/>
        </a:p>
        <a:p>
          <a:pPr marL="57150" lvl="1" indent="-57150" algn="l" defTabSz="4445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000" kern="1200" dirty="0"/>
        </a:p>
      </dsp:txBody>
      <dsp:txXfrm>
        <a:off x="1170188" y="2031358"/>
        <a:ext cx="1408929" cy="2152189"/>
      </dsp:txXfrm>
    </dsp:sp>
    <dsp:sp modelId="{AE8C43CD-72A9-4611-AAA1-7A65254F2684}">
      <dsp:nvSpPr>
        <dsp:cNvPr id="0" name=""/>
        <dsp:cNvSpPr/>
      </dsp:nvSpPr>
      <dsp:spPr>
        <a:xfrm>
          <a:off x="0" y="2536334"/>
          <a:ext cx="1196737" cy="1142547"/>
        </a:xfrm>
        <a:prstGeom prst="ellipse">
          <a:avLst/>
        </a:prstGeom>
        <a:gradFill rotWithShape="0">
          <a:gsLst>
            <a:gs pos="0">
              <a:schemeClr val="accent2">
                <a:hueOff val="0"/>
                <a:satOff val="0"/>
                <a:lumOff val="0"/>
                <a:alphaOff val="0"/>
                <a:satMod val="103000"/>
                <a:lumMod val="102000"/>
                <a:tint val="94000"/>
              </a:schemeClr>
            </a:gs>
            <a:gs pos="50000">
              <a:schemeClr val="accent2">
                <a:hueOff val="0"/>
                <a:satOff val="0"/>
                <a:lumOff val="0"/>
                <a:alphaOff val="0"/>
                <a:satMod val="110000"/>
                <a:lumMod val="100000"/>
                <a:shade val="100000"/>
              </a:schemeClr>
            </a:gs>
            <a:gs pos="100000">
              <a:schemeClr val="accent2">
                <a:hueOff val="0"/>
                <a:satOff val="0"/>
                <a:lumOff val="0"/>
                <a:alphaOff val="0"/>
                <a:lumMod val="99000"/>
                <a:satMod val="120000"/>
                <a:shade val="78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plastic">
          <a:bevelT w="120900" h="88900"/>
          <a:bevelB w="88900" h="31750" prst="angle"/>
        </a:sp3d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400" kern="1200" dirty="0"/>
            <a:t>Patient Identifiable </a:t>
          </a:r>
          <a:r>
            <a:rPr lang="en-GB" sz="1400" kern="1200" dirty="0" smtClean="0"/>
            <a:t>Data</a:t>
          </a:r>
          <a:endParaRPr lang="en-GB" sz="1400" kern="1200" dirty="0"/>
        </a:p>
      </dsp:txBody>
      <dsp:txXfrm>
        <a:off x="175258" y="2703656"/>
        <a:ext cx="846221" cy="807903"/>
      </dsp:txXfrm>
    </dsp:sp>
    <dsp:sp modelId="{DB921617-3D76-43EA-9080-A6928D957AC0}">
      <dsp:nvSpPr>
        <dsp:cNvPr id="0" name=""/>
        <dsp:cNvSpPr/>
      </dsp:nvSpPr>
      <dsp:spPr>
        <a:xfrm>
          <a:off x="3953654" y="2139657"/>
          <a:ext cx="2890111" cy="1995919"/>
        </a:xfrm>
        <a:prstGeom prst="rightArrow">
          <a:avLst>
            <a:gd name="adj1" fmla="val 70000"/>
            <a:gd name="adj2" fmla="val 50000"/>
          </a:avLst>
        </a:prstGeom>
        <a:solidFill>
          <a:schemeClr val="accent2">
            <a:tint val="40000"/>
            <a:alpha val="90000"/>
            <a:hueOff val="-424613"/>
            <a:satOff val="-37673"/>
            <a:lumOff val="-385"/>
            <a:alphaOff val="0"/>
          </a:schemeClr>
        </a:solidFill>
        <a:ln w="6350" cap="flat" cmpd="sng" algn="ctr">
          <a:solidFill>
            <a:schemeClr val="accent2">
              <a:tint val="40000"/>
              <a:alpha val="90000"/>
              <a:hueOff val="-424613"/>
              <a:satOff val="-37673"/>
              <a:lumOff val="-385"/>
              <a:alphaOff val="0"/>
            </a:schemeClr>
          </a:solidFill>
          <a:prstDash val="solid"/>
          <a:miter lim="800000"/>
        </a:ln>
        <a:effectLst/>
        <a:scene3d>
          <a:camera prst="orthographicFront"/>
          <a:lightRig rig="flat" dir="t"/>
        </a:scene3d>
        <a:sp3d z="-190500" extrusionH="12700" prstMaterial="plastic">
          <a:bevelT w="50800" h="50800"/>
        </a:sp3d>
      </dsp:spPr>
      <dsp:style>
        <a:lnRef idx="1">
          <a:scrgbClr r="0" g="0" b="0"/>
        </a:lnRef>
        <a:fillRef idx="1">
          <a:scrgbClr r="0" g="0" b="0"/>
        </a:fillRef>
        <a:effectRef idx="2">
          <a:scrgbClr r="0" g="0" b="0"/>
        </a:effectRef>
        <a:fontRef idx="minor"/>
      </dsp:style>
      <dsp:txBody>
        <a:bodyPr spcFirstLastPara="0" vert="horz" wrap="square" lIns="33020" tIns="8255" rIns="16510" bIns="8255" numCol="1" spcCol="1270" anchor="ctr" anchorCtr="0">
          <a:noAutofit/>
        </a:bodyPr>
        <a:lstStyle/>
        <a:p>
          <a:pPr marL="114300" lvl="1" indent="-114300" algn="l" defTabSz="5778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300" kern="1200" dirty="0"/>
            <a:t>Unique ID</a:t>
          </a:r>
        </a:p>
        <a:p>
          <a:pPr marL="114300" lvl="1" indent="-114300" algn="l" defTabSz="5778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300" kern="1200" dirty="0"/>
            <a:t>Clinical outcomes</a:t>
          </a:r>
        </a:p>
        <a:p>
          <a:pPr marL="114300" lvl="1" indent="-114300" algn="l" defTabSz="5778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300" kern="1200" dirty="0"/>
            <a:t>Responses to AHA Cholesterol Care Plan </a:t>
          </a:r>
          <a:r>
            <a:rPr lang="en-GB" sz="1300" kern="1200" dirty="0" smtClean="0"/>
            <a:t>&amp; additional </a:t>
          </a:r>
          <a:r>
            <a:rPr lang="en-GB" sz="1300" kern="1200" dirty="0" smtClean="0"/>
            <a:t>Web </a:t>
          </a:r>
          <a:r>
            <a:rPr lang="en-GB" sz="1300" kern="1200" dirty="0" smtClean="0"/>
            <a:t>app ?s</a:t>
          </a:r>
          <a:endParaRPr lang="en-GB" sz="1300" kern="1200" dirty="0"/>
        </a:p>
      </dsp:txBody>
      <dsp:txXfrm>
        <a:off x="4676182" y="2439045"/>
        <a:ext cx="1469011" cy="1397143"/>
      </dsp:txXfrm>
    </dsp:sp>
    <dsp:sp modelId="{DB9C4CDC-829A-4D3A-836C-CB22248CED44}">
      <dsp:nvSpPr>
        <dsp:cNvPr id="0" name=""/>
        <dsp:cNvSpPr/>
      </dsp:nvSpPr>
      <dsp:spPr>
        <a:xfrm>
          <a:off x="3368992" y="2499608"/>
          <a:ext cx="1271836" cy="1163833"/>
        </a:xfrm>
        <a:prstGeom prst="ellipse">
          <a:avLst/>
        </a:prstGeom>
        <a:gradFill rotWithShape="0">
          <a:gsLst>
            <a:gs pos="0">
              <a:schemeClr val="accent2">
                <a:hueOff val="-727682"/>
                <a:satOff val="-41964"/>
                <a:lumOff val="4314"/>
                <a:alphaOff val="0"/>
                <a:satMod val="103000"/>
                <a:lumMod val="102000"/>
                <a:tint val="94000"/>
              </a:schemeClr>
            </a:gs>
            <a:gs pos="50000">
              <a:schemeClr val="accent2">
                <a:hueOff val="-727682"/>
                <a:satOff val="-41964"/>
                <a:lumOff val="4314"/>
                <a:alphaOff val="0"/>
                <a:satMod val="110000"/>
                <a:lumMod val="100000"/>
                <a:shade val="100000"/>
              </a:schemeClr>
            </a:gs>
            <a:gs pos="100000">
              <a:schemeClr val="accent2">
                <a:hueOff val="-727682"/>
                <a:satOff val="-41964"/>
                <a:lumOff val="4314"/>
                <a:alphaOff val="0"/>
                <a:lumMod val="99000"/>
                <a:satMod val="120000"/>
                <a:shade val="78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plastic">
          <a:bevelT w="120900" h="88900"/>
          <a:bevelB w="88900" h="31750" prst="angle"/>
        </a:sp3d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400" kern="1200" dirty="0"/>
            <a:t>Anonymous </a:t>
          </a:r>
          <a:r>
            <a:rPr lang="en-GB" sz="1400" kern="1200" dirty="0" smtClean="0"/>
            <a:t>Data</a:t>
          </a:r>
          <a:endParaRPr lang="en-GB" sz="1400" kern="1200" dirty="0"/>
        </a:p>
      </dsp:txBody>
      <dsp:txXfrm>
        <a:off x="3555248" y="2670047"/>
        <a:ext cx="899324" cy="822955"/>
      </dsp:txXfrm>
    </dsp:sp>
    <dsp:sp modelId="{AAAB698C-F27B-44AE-89C0-200949C3E0BF}">
      <dsp:nvSpPr>
        <dsp:cNvPr id="0" name=""/>
        <dsp:cNvSpPr/>
      </dsp:nvSpPr>
      <dsp:spPr>
        <a:xfrm>
          <a:off x="7494705" y="1675534"/>
          <a:ext cx="2890111" cy="3158911"/>
        </a:xfrm>
        <a:prstGeom prst="rightArrow">
          <a:avLst>
            <a:gd name="adj1" fmla="val 70000"/>
            <a:gd name="adj2" fmla="val 50000"/>
          </a:avLst>
        </a:prstGeom>
        <a:solidFill>
          <a:schemeClr val="accent2">
            <a:tint val="40000"/>
            <a:alpha val="90000"/>
            <a:hueOff val="-849226"/>
            <a:satOff val="-75346"/>
            <a:lumOff val="-769"/>
            <a:alphaOff val="0"/>
          </a:schemeClr>
        </a:solidFill>
        <a:ln w="6350" cap="flat" cmpd="sng" algn="ctr">
          <a:solidFill>
            <a:schemeClr val="accent2">
              <a:tint val="40000"/>
              <a:alpha val="90000"/>
              <a:hueOff val="-849226"/>
              <a:satOff val="-75346"/>
              <a:lumOff val="-769"/>
              <a:alphaOff val="0"/>
            </a:schemeClr>
          </a:solidFill>
          <a:prstDash val="solid"/>
          <a:miter lim="800000"/>
        </a:ln>
        <a:effectLst/>
        <a:scene3d>
          <a:camera prst="orthographicFront"/>
          <a:lightRig rig="flat" dir="t"/>
        </a:scene3d>
        <a:sp3d z="-190500" extrusionH="12700" prstMaterial="plastic">
          <a:bevelT w="50800" h="50800"/>
        </a:sp3d>
      </dsp:spPr>
      <dsp:style>
        <a:lnRef idx="1">
          <a:scrgbClr r="0" g="0" b="0"/>
        </a:lnRef>
        <a:fillRef idx="1">
          <a:scrgbClr r="0" g="0" b="0"/>
        </a:fillRef>
        <a:effectRef idx="2">
          <a:scrgbClr r="0" g="0" b="0"/>
        </a:effectRef>
        <a:fontRef idx="minor"/>
      </dsp:style>
      <dsp:txBody>
        <a:bodyPr spcFirstLastPara="0" vert="horz" wrap="square" lIns="33020" tIns="8255" rIns="16510" bIns="8255" numCol="1" spcCol="1270" anchor="ctr" anchorCtr="0">
          <a:noAutofit/>
        </a:bodyPr>
        <a:lstStyle/>
        <a:p>
          <a:pPr marL="57150" lvl="1" indent="-57150" algn="l" defTabSz="488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100" kern="1200" dirty="0"/>
        </a:p>
        <a:p>
          <a:pPr marL="114300" lvl="1" indent="-114300" algn="l" defTabSz="5778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300" kern="1200" dirty="0"/>
            <a:t>Unique ID</a:t>
          </a:r>
        </a:p>
        <a:p>
          <a:pPr marL="114300" lvl="1" indent="-114300" algn="l" defTabSz="5778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300" kern="1200" dirty="0"/>
            <a:t>Clinical outcomes</a:t>
          </a:r>
        </a:p>
        <a:p>
          <a:pPr marL="114300" lvl="1" indent="-114300" algn="l" defTabSz="5778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300" kern="1200" dirty="0"/>
            <a:t>Responses to AHA Cholesterol Care Plan </a:t>
          </a:r>
          <a:r>
            <a:rPr lang="en-GB" sz="1300" kern="1200" dirty="0" smtClean="0"/>
            <a:t>&amp; additional </a:t>
          </a:r>
          <a:r>
            <a:rPr lang="en-GB" sz="1300" kern="1200" dirty="0" smtClean="0"/>
            <a:t>Web </a:t>
          </a:r>
          <a:r>
            <a:rPr lang="en-GB" sz="1300" kern="1200" dirty="0" smtClean="0"/>
            <a:t>app ?s</a:t>
          </a:r>
          <a:endParaRPr lang="en-GB" sz="1300" kern="1200" dirty="0"/>
        </a:p>
        <a:p>
          <a:pPr marL="114300" lvl="1" indent="-114300" algn="l" defTabSz="5778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300" kern="1200" dirty="0"/>
            <a:t>Patient Consent Form</a:t>
          </a:r>
        </a:p>
      </dsp:txBody>
      <dsp:txXfrm>
        <a:off x="8217233" y="2149371"/>
        <a:ext cx="1408929" cy="2211237"/>
      </dsp:txXfrm>
    </dsp:sp>
    <dsp:sp modelId="{651066C6-62ED-4D8C-AE28-B19E8DDBBC20}">
      <dsp:nvSpPr>
        <dsp:cNvPr id="0" name=""/>
        <dsp:cNvSpPr/>
      </dsp:nvSpPr>
      <dsp:spPr>
        <a:xfrm>
          <a:off x="6856677" y="2592843"/>
          <a:ext cx="1315795" cy="1073112"/>
        </a:xfrm>
        <a:prstGeom prst="ellipse">
          <a:avLst/>
        </a:prstGeom>
        <a:gradFill rotWithShape="0">
          <a:gsLst>
            <a:gs pos="0">
              <a:schemeClr val="accent2">
                <a:hueOff val="-1455363"/>
                <a:satOff val="-83928"/>
                <a:lumOff val="8628"/>
                <a:alphaOff val="0"/>
                <a:satMod val="103000"/>
                <a:lumMod val="102000"/>
                <a:tint val="94000"/>
              </a:schemeClr>
            </a:gs>
            <a:gs pos="50000">
              <a:schemeClr val="accent2">
                <a:hueOff val="-1455363"/>
                <a:satOff val="-83928"/>
                <a:lumOff val="8628"/>
                <a:alphaOff val="0"/>
                <a:satMod val="110000"/>
                <a:lumMod val="100000"/>
                <a:shade val="100000"/>
              </a:schemeClr>
            </a:gs>
            <a:gs pos="100000">
              <a:schemeClr val="accent2">
                <a:hueOff val="-1455363"/>
                <a:satOff val="-83928"/>
                <a:lumOff val="8628"/>
                <a:alphaOff val="0"/>
                <a:lumMod val="99000"/>
                <a:satMod val="120000"/>
                <a:shade val="78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plastic">
          <a:bevelT w="120900" h="88900"/>
          <a:bevelB w="88900" h="31750" prst="angle"/>
        </a:sp3d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GB" sz="1400" kern="1200" dirty="0" smtClean="0"/>
        </a:p>
        <a:p>
          <a:pPr lvl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400" kern="1200" dirty="0" smtClean="0"/>
            <a:t>Pseudo-</a:t>
          </a:r>
          <a:r>
            <a:rPr lang="en-GB" sz="1400" kern="1200" dirty="0" err="1" smtClean="0"/>
            <a:t>nymised</a:t>
          </a:r>
          <a:r>
            <a:rPr lang="en-GB" sz="1400" kern="1200" dirty="0" smtClean="0"/>
            <a:t> </a:t>
          </a:r>
        </a:p>
        <a:p>
          <a:pPr lvl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400" kern="1200" dirty="0" smtClean="0"/>
            <a:t>Data</a:t>
          </a:r>
          <a:endParaRPr lang="en-GB" sz="1400" kern="1200" dirty="0"/>
        </a:p>
        <a:p>
          <a:pPr lvl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GB" sz="1400" kern="1200" dirty="0"/>
        </a:p>
      </dsp:txBody>
      <dsp:txXfrm>
        <a:off x="7049371" y="2749997"/>
        <a:ext cx="930407" cy="758804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hProcess6">
  <dgm:title val=""/>
  <dgm:desc val=""/>
  <dgm:catLst>
    <dgm:cat type="process" pri="7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  <dgm:pt modelId="32">
          <dgm:prSet phldr="1"/>
        </dgm:pt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14" srcId="1" destId="12" srcOrd="0" destOrd="0"/>
        <dgm:cxn modelId="23" srcId="2" destId="21" srcOrd="0" destOrd="0"/>
        <dgm:cxn modelId="24" srcId="2" destId="22" srcOrd="0" destOrd="0"/>
        <dgm:cxn modelId="33" srcId="3" destId="31" srcOrd="0" destOrd="0"/>
        <dgm:cxn modelId="34" srcId="3" destId="32" srcOrd="0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2"/>
        <dgm:pt modelId="21"/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23" srcId="2" destId="21" srcOrd="0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2"/>
        <dgm:pt modelId="21"/>
        <dgm:pt modelId="3"/>
        <dgm:pt modelId="31"/>
        <dgm:pt modelId="4"/>
        <dgm:pt modelId="41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theList">
    <dgm:varLst>
      <dgm:dir/>
      <dgm:animLvl val="lvl"/>
      <dgm:resizeHandles val="exact"/>
    </dgm:varLst>
    <dgm:choose name="Name0">
      <dgm:if name="Name1" func="var" arg="dir" op="equ" val="norm">
        <dgm:alg type="lin">
          <dgm:param type="linDir" val="fromL"/>
          <dgm:param type="nodeHorzAlign" val="l"/>
        </dgm:alg>
      </dgm:if>
      <dgm:else name="Name2">
        <dgm:alg type="lin">
          <dgm:param type="linDir" val="fromR"/>
          <dgm:param type="nodeHorzAlign" val="r"/>
        </dgm:alg>
      </dgm:else>
    </dgm:choose>
    <dgm:shape xmlns:r="http://schemas.openxmlformats.org/officeDocument/2006/relationships" r:blip="">
      <dgm:adjLst/>
    </dgm:shape>
    <dgm:presOf/>
    <dgm:constrLst>
      <dgm:constr type="w" for="ch" forName="compNode" refType="w"/>
      <dgm:constr type="h" for="ch" forName="compNode" refType="w" refFor="ch" refForName="compNode" fact="0.7"/>
      <dgm:constr type="ctrY" for="ch" forName="compNode" refType="h" fact="0.5"/>
      <dgm:constr type="w" for="ch" forName="aSpace" refType="w" fact="0.05"/>
      <dgm:constr type="primFontSz" for="des" forName="childTextHidden" op="equ" val="65"/>
      <dgm:constr type="primFontSz" for="des" forName="parentText" op="equ"/>
    </dgm:constrLst>
    <dgm:ruleLst/>
    <dgm:forEach name="aNodeForEach" axis="ch" ptType="node">
      <dgm:layoutNode name="compNode">
        <dgm:alg type="composite">
          <dgm:param type="ar" val="1.43"/>
        </dgm:alg>
        <dgm:shape xmlns:r="http://schemas.openxmlformats.org/officeDocument/2006/relationships" r:blip="">
          <dgm:adjLst/>
        </dgm:shape>
        <dgm:presOf/>
        <dgm:choose name="Name3">
          <dgm:if name="Name4" func="var" arg="dir" op="equ" val="norm">
            <dgm:constrLst>
              <dgm:constr type="w" for="ch" forName="childTextVisible" refType="w" fact="0.8"/>
              <dgm:constr type="h" for="ch" forName="childTextVisible" refType="h"/>
              <dgm:constr type="r" for="ch" forName="childTextVisible" refType="w"/>
              <dgm:constr type="w" for="ch" forName="childTextHidden" refType="w" fact="0.6"/>
              <dgm:constr type="h" for="ch" forName="childTextHidden" refType="h"/>
              <dgm:constr type="r" for="ch" forName="childTextHidden" refType="w"/>
              <dgm:constr type="l" for="ch" forName="parentText"/>
              <dgm:constr type="w" for="ch" forName="parentText" refType="w" fact="0.4"/>
              <dgm:constr type="h" for="ch" forName="parentText" refType="w" refFor="ch" refForName="parentText" op="equ"/>
              <dgm:constr type="ctrY" for="ch" forName="parentText" refType="h" fact="0.5"/>
            </dgm:constrLst>
          </dgm:if>
          <dgm:else name="Name5">
            <dgm:constrLst>
              <dgm:constr type="w" for="ch" forName="childTextVisible" refType="w" fact="0.8"/>
              <dgm:constr type="h" for="ch" forName="childTextVisible" refType="h"/>
              <dgm:constr type="l" for="ch" forName="childTextVisible"/>
              <dgm:constr type="w" for="ch" forName="childTextHidden" refType="w" fact="0.6"/>
              <dgm:constr type="h" for="ch" forName="childTextHidden" refType="h"/>
              <dgm:constr type="l" for="ch" forName="childTextHidden"/>
              <dgm:constr type="r" for="ch" forName="parentText" refType="w"/>
              <dgm:constr type="w" for="ch" forName="parentText" refType="w" fact="0.4"/>
              <dgm:constr type="h" for="ch" forName="parentText" refType="w" refFor="ch" refForName="parentText" op="equ"/>
              <dgm:constr type="ctrY" for="ch" forName="parentText" refType="h" fact="0.5"/>
            </dgm:constrLst>
          </dgm:else>
        </dgm:choose>
        <dgm:ruleLst/>
        <dgm:layoutNode name="noGeometry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  <dgm:layoutNode name="childTextVisible" styleLbl="bgAccFollowNode1">
          <dgm:varLst>
            <dgm:bulletEnabled val="1"/>
          </dgm:varLst>
          <dgm:alg type="sp"/>
          <dgm:choose name="Name6">
            <dgm:if name="Name7" func="var" arg="dir" op="equ" val="norm">
              <dgm:shape xmlns:r="http://schemas.openxmlformats.org/officeDocument/2006/relationships" type="rightArrow" r:blip="">
                <dgm:adjLst>
                  <dgm:adj idx="1" val="0.7"/>
                  <dgm:adj idx="2" val="0.5"/>
                </dgm:adjLst>
              </dgm:shape>
            </dgm:if>
            <dgm:else name="Name8">
              <dgm:shape xmlns:r="http://schemas.openxmlformats.org/officeDocument/2006/relationships" type="leftArrow" r:blip="">
                <dgm:adjLst>
                  <dgm:adj idx="1" val="0.7"/>
                  <dgm:adj idx="2" val="0.5"/>
                </dgm:adjLst>
              </dgm:shape>
            </dgm:else>
          </dgm:choose>
          <dgm:presOf axis="des" ptType="node"/>
          <dgm:constrLst/>
          <dgm:ruleLst/>
        </dgm:layoutNode>
        <dgm:layoutNode name="childTextHidden" styleLbl="bgAccFollowNode1">
          <dgm:choose name="Name9">
            <dgm:if name="Name10" axis="des followSib" ptType="node node" st="1 1" cnt="1 0" func="cnt" op="gte" val="1">
              <dgm:alg type="tx">
                <dgm:param type="stBulletLvl" val="1"/>
                <dgm:param type="txAnchorVertCh" val="mid"/>
              </dgm:alg>
            </dgm:if>
            <dgm:else name="Name11">
              <dgm:alg type="tx">
                <dgm:param type="stBulletLvl" val="2"/>
                <dgm:param type="txAnchorVertCh" val="mid"/>
              </dgm:alg>
            </dgm:else>
          </dgm:choose>
          <dgm:choose name="Name12">
            <dgm:if name="Name13" func="var" arg="dir" op="equ" val="norm">
              <dgm:shape xmlns:r="http://schemas.openxmlformats.org/officeDocument/2006/relationships" type="rightArrow" r:blip="" hideGeom="1">
                <dgm:adjLst>
                  <dgm:adj idx="1" val="0.7"/>
                  <dgm:adj idx="2" val="0.5"/>
                </dgm:adjLst>
              </dgm:shape>
            </dgm:if>
            <dgm:else name="Name14">
              <dgm:shape xmlns:r="http://schemas.openxmlformats.org/officeDocument/2006/relationships" type="leftArrow" r:blip="" hideGeom="1">
                <dgm:adjLst>
                  <dgm:adj idx="1" val="0.7"/>
                  <dgm:adj idx="2" val="0.5"/>
                </dgm:adjLst>
              </dgm:shape>
            </dgm:else>
          </dgm:choose>
          <dgm:presOf axis="des" ptType="node"/>
          <dgm:constrLst>
            <dgm:constr type="secFontSz" refType="primFontSz"/>
            <dgm:constr type="tMarg" refType="primFontSz" fact="0.05"/>
            <dgm:constr type="bMarg" refType="primFontSz" fact="0.05"/>
            <dgm:constr type="rMarg" refType="primFontSz" fact="0.1"/>
            <dgm:constr type="lMarg" refType="primFontSz" fact="0.2"/>
          </dgm:constrLst>
          <dgm:ruleLst>
            <dgm:rule type="primFontSz" val="5" fact="NaN" max="NaN"/>
          </dgm:ruleLst>
        </dgm:layoutNode>
        <dgm:layoutNode name="parentText" styleLbl="node1">
          <dgm:varLst>
            <dgm:chMax val="1"/>
            <dgm:bulletEnabled val="1"/>
          </dgm:varLst>
          <dgm:alg type="tx"/>
          <dgm:shape xmlns:r="http://schemas.openxmlformats.org/officeDocument/2006/relationships" type="ellipse" r:blip="">
            <dgm:adjLst/>
          </dgm:shape>
          <dgm:presOf axis="self"/>
          <dgm:constrLst>
            <dgm:constr type="primFontSz" val="65"/>
            <dgm:constr type="tMarg" refType="primFontSz" fact="0.05"/>
            <dgm:constr type="bMarg" refType="primFontSz" fact="0.05"/>
            <dgm:constr type="lMarg" refType="primFontSz" fact="0.05"/>
            <dgm:constr type="rMarg" refType="primFontSz" fact="0.05"/>
          </dgm:constrLst>
          <dgm:ruleLst>
            <dgm:rule type="primFontSz" val="5" fact="NaN" max="NaN"/>
          </dgm:ruleLst>
        </dgm:layoutNode>
      </dgm:layoutNode>
      <dgm:choose name="Name15">
        <dgm:if name="Name16" axis="self" ptType="node" func="revPos" op="gte" val="2">
          <dgm:layoutNode name="aSpace">
            <dgm:alg type="sp"/>
            <dgm:shape xmlns:r="http://schemas.openxmlformats.org/officeDocument/2006/relationships" r:blip="">
              <dgm:adjLst/>
            </dgm:shape>
            <dgm:presOf/>
            <dgm:constrLst/>
            <dgm:ruleLst/>
          </dgm:layoutNode>
        </dgm:if>
        <dgm:else name="Name17"/>
      </dgm:choose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3d1">
  <dgm:title val=""/>
  <dgm:desc val=""/>
  <dgm:catLst>
    <dgm:cat type="3D" pri="11100"/>
  </dgm:catLst>
  <dgm:scene3d>
    <a:camera prst="orthographicFront"/>
    <a:lightRig rig="threePt" dir="t"/>
  </dgm:scene3d>
  <dgm:styleLbl name="node0">
    <dgm:scene3d>
      <a:camera prst="orthographicFront"/>
      <a:lightRig rig="flat" dir="t"/>
    </dgm:scene3d>
    <dgm:sp3d prstMaterial="plastic">
      <a:bevelT w="120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flat" dir="t"/>
    </dgm:scene3d>
    <dgm:sp3d prstMaterial="plastic">
      <a:bevelT w="120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flat" dir="t"/>
    </dgm:scene3d>
    <dgm:sp3d prstMaterial="plastic">
      <a:bevelT w="120900" h="88900"/>
      <a:bevelB w="88900" h="31750" prst="angle"/>
    </dgm:sp3d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flat" dir="t"/>
    </dgm:scene3d>
    <dgm:sp3d prstMaterial="plastic">
      <a:bevelT w="120900" h="88900"/>
      <a:bevelB w="88900" h="31750" prst="angle"/>
    </dgm:sp3d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flat" dir="t"/>
    </dgm:scene3d>
    <dgm:sp3d prstMaterial="plastic">
      <a:bevelT w="120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flat" dir="t"/>
    </dgm:scene3d>
    <dgm:sp3d prstMaterial="plastic">
      <a:bevelT w="120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flat" dir="t"/>
    </dgm:scene3d>
    <dgm:sp3d prstMaterial="plastic">
      <a:bevelT w="120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flat" dir="t"/>
    </dgm:scene3d>
    <dgm:sp3d prstMaterial="plastic">
      <a:bevelT w="120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flat" dir="t"/>
    </dgm:scene3d>
    <dgm:sp3d z="127000" prstMaterial="plastic">
      <a:bevelT w="88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/>
    </dgm:style>
  </dgm:styleLbl>
  <dgm:styleLbl name="alignImgPlace1">
    <dgm:scene3d>
      <a:camera prst="orthographicFront"/>
      <a:lightRig rig="flat" dir="t"/>
    </dgm:scene3d>
    <dgm:sp3d prstMaterial="plastic">
      <a:bevelT w="88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/>
    </dgm:style>
  </dgm:styleLbl>
  <dgm:styleLbl name="bgImgPlace1">
    <dgm:scene3d>
      <a:camera prst="orthographicFront"/>
      <a:lightRig rig="flat" dir="t"/>
    </dgm:scene3d>
    <dgm:sp3d z="-190500" prstMaterial="plastic">
      <a:bevelT w="88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/>
    </dgm:style>
  </dgm:styleLbl>
  <dgm:styleLbl name="sibTrans2D1">
    <dgm:scene3d>
      <a:camera prst="orthographicFront"/>
      <a:lightRig rig="flat" dir="t"/>
    </dgm:scene3d>
    <dgm:sp3d z="-80000" prstMaterial="plastic">
      <a:bevelT w="50800" h="50800"/>
      <a:bevelB w="25400" h="25400" prst="angle"/>
    </dgm:sp3d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flat" dir="t"/>
    </dgm:scene3d>
    <dgm:sp3d z="127000" prstMaterial="plastic">
      <a:bevelT w="50800" h="50800"/>
      <a:bevelB w="25400" h="25400" prst="angle"/>
    </dgm:sp3d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flat" dir="t"/>
    </dgm:scene3d>
    <dgm:sp3d z="-190500" prstMaterial="plastic">
      <a:bevelT w="50800" h="50800"/>
      <a:bevelB w="25400" h="25400" prst="angle"/>
    </dgm:sp3d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flat" dir="t"/>
    </dgm:scene3d>
    <dgm:sp3d z="-40000" prstMaterial="matte"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 z="127000" prstMaterial="matte"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flat" dir="t"/>
    </dgm:scene3d>
    <dgm:sp3d prstMaterial="plastic">
      <a:bevelT w="120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flat" dir="t"/>
    </dgm:scene3d>
    <dgm:sp3d prstMaterial="plastic">
      <a:bevelT w="120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flat" dir="t"/>
    </dgm:scene3d>
    <dgm:sp3d prstMaterial="plastic">
      <a:bevelT w="120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flat" dir="t"/>
    </dgm:scene3d>
    <dgm:sp3d prstMaterial="plastic">
      <a:bevelT w="120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flat" dir="t"/>
    </dgm:scene3d>
    <dgm:sp3d z="-100000" prstMaterial="plastic">
      <a:bevelT w="120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flat" dir="t"/>
    </dgm:scene3d>
    <dgm:sp3d z="-60000" prstMaterial="plastic">
      <a:bevelT w="120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flat" dir="t"/>
    </dgm:scene3d>
    <dgm:sp3d z="-60000" prstMaterial="plastic">
      <a:bevelT w="120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flat" dir="t"/>
    </dgm:scene3d>
    <dgm:sp3d z="-60000" prstMaterial="plastic">
      <a:bevelT w="120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flat" dir="t"/>
    </dgm:scene3d>
    <dgm:sp3d prstMaterial="matte"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flat" dir="t"/>
    </dgm:scene3d>
    <dgm:sp3d prstMaterial="matte"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flat" dir="t"/>
    </dgm:scene3d>
    <dgm:sp3d prstMaterial="matte"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flat" dir="t"/>
    </dgm:scene3d>
    <dgm:sp3d prstMaterial="matte"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flat" dir="t"/>
    </dgm:scene3d>
    <dgm:sp3d z="190500"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conFgAcc1">
    <dgm:scene3d>
      <a:camera prst="orthographicFront"/>
      <a:lightRig rig="flat" dir="t"/>
    </dgm:scene3d>
    <dgm:sp3d z="190500"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alignAcc1">
    <dgm:scene3d>
      <a:camera prst="orthographicFront"/>
      <a:lightRig rig="flat" dir="t"/>
    </dgm:scene3d>
    <dgm:sp3d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trAlignAcc1">
    <dgm:scene3d>
      <a:camera prst="orthographicFront"/>
      <a:lightRig rig="flat" dir="t"/>
    </dgm:scene3d>
    <dgm:sp3d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bgAcc1">
    <dgm:scene3d>
      <a:camera prst="orthographicFront"/>
      <a:lightRig rig="flat" dir="t"/>
    </dgm:scene3d>
    <dgm:sp3d z="-190500"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solidFgAcc1">
    <dgm:scene3d>
      <a:camera prst="orthographicFront"/>
      <a:lightRig rig="flat" dir="t"/>
    </dgm:scene3d>
    <dgm:sp3d z="190500"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solidAlignAcc1">
    <dgm:scene3d>
      <a:camera prst="orthographicFront"/>
      <a:lightRig rig="flat" dir="t"/>
    </dgm:scene3d>
    <dgm:sp3d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solidBgAcc1">
    <dgm:scene3d>
      <a:camera prst="orthographicFront"/>
      <a:lightRig rig="flat" dir="t"/>
    </dgm:scene3d>
    <dgm:sp3d z="-190500"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fgAccFollowNode1">
    <dgm:scene3d>
      <a:camera prst="orthographicFront"/>
      <a:lightRig rig="flat" dir="t"/>
    </dgm:scene3d>
    <dgm:sp3d z="190500"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alignAccFollowNode1">
    <dgm:scene3d>
      <a:camera prst="orthographicFront"/>
      <a:lightRig rig="flat" dir="t"/>
    </dgm:scene3d>
    <dgm:sp3d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bgAccFollowNode1">
    <dgm:scene3d>
      <a:camera prst="orthographicFront"/>
      <a:lightRig rig="flat" dir="t"/>
    </dgm:scene3d>
    <dgm:sp3d z="-190500"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fgAcc0">
    <dgm:scene3d>
      <a:camera prst="orthographicFront"/>
      <a:lightRig rig="flat" dir="t"/>
    </dgm:scene3d>
    <dgm:sp3d z="190500"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fgAcc2">
    <dgm:scene3d>
      <a:camera prst="orthographicFront"/>
      <a:lightRig rig="flat" dir="t"/>
    </dgm:scene3d>
    <dgm:sp3d z="190500"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fgAcc3">
    <dgm:scene3d>
      <a:camera prst="orthographicFront"/>
      <a:lightRig rig="flat" dir="t"/>
    </dgm:scene3d>
    <dgm:sp3d z="190500"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fgAcc4">
    <dgm:scene3d>
      <a:camera prst="orthographicFront"/>
      <a:lightRig rig="flat" dir="t"/>
    </dgm:scene3d>
    <dgm:sp3d z="190500"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bgShp">
    <dgm:scene3d>
      <a:camera prst="orthographicFront"/>
      <a:lightRig rig="flat" dir="t"/>
    </dgm:scene3d>
    <dgm:sp3d z="-190500" extrusionH="12700" prstMaterial="plastic">
      <a:bevelT w="50800" h="50800"/>
    </dgm:sp3d>
    <dgm:txPr/>
    <dgm:style>
      <a:lnRef idx="0">
        <a:scrgbClr r="0" g="0" b="0"/>
      </a:lnRef>
      <a:fillRef idx="3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flat" dir="t"/>
    </dgm:scene3d>
    <dgm:sp3d z="-190500" extrusionH="12700" prstMaterial="plastic">
      <a:bevelT w="50800" h="50800"/>
    </dgm:sp3d>
    <dgm:txPr/>
    <dgm:style>
      <a:lnRef idx="0">
        <a:scrgbClr r="0" g="0" b="0"/>
      </a:lnRef>
      <a:fillRef idx="2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flat" dir="t"/>
    </dgm:scene3d>
    <dgm:sp3d z="-190500" extrusionH="12700" prstMaterial="matte"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flat" dir="t"/>
    </dgm:scene3d>
    <dgm:sp3d z="190500" prstMaterial="plastic">
      <a:bevelT w="120900" h="88900"/>
      <a:bevelB w="88900" h="31750" prst="angle"/>
    </dgm:sp3d>
    <dgm:txPr/>
    <dgm:style>
      <a:lnRef idx="0">
        <a:scrgbClr r="0" g="0" b="0"/>
      </a:lnRef>
      <a:fillRef idx="1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E95E6-2A53-449E-9BA3-46D25A515922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8186F-0DA3-4E71-AD1C-CCC7B701C1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71759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E95E6-2A53-449E-9BA3-46D25A515922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8186F-0DA3-4E71-AD1C-CCC7B701C1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4732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E95E6-2A53-449E-9BA3-46D25A515922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8186F-0DA3-4E71-AD1C-CCC7B701C1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348535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E95E6-2A53-449E-9BA3-46D25A515922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8186F-0DA3-4E71-AD1C-CCC7B701C1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34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E95E6-2A53-449E-9BA3-46D25A515922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8186F-0DA3-4E71-AD1C-CCC7B701C1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27015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E95E6-2A53-449E-9BA3-46D25A515922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8186F-0DA3-4E71-AD1C-CCC7B701C1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93975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E95E6-2A53-449E-9BA3-46D25A515922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8186F-0DA3-4E71-AD1C-CCC7B701C1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43171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E95E6-2A53-449E-9BA3-46D25A515922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8186F-0DA3-4E71-AD1C-CCC7B701C1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70144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E95E6-2A53-449E-9BA3-46D25A515922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8186F-0DA3-4E71-AD1C-CCC7B701C1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66992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E95E6-2A53-449E-9BA3-46D25A515922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8186F-0DA3-4E71-AD1C-CCC7B701C1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66963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E95E6-2A53-449E-9BA3-46D25A515922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8186F-0DA3-4E71-AD1C-CCC7B701C1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70431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DE95E6-2A53-449E-9BA3-46D25A515922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08186F-0DA3-4E71-AD1C-CCC7B701C1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427282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7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Diagram 2"/>
          <p:cNvGraphicFramePr/>
          <p:nvPr>
            <p:extLst>
              <p:ext uri="{D42A27DB-BD31-4B8C-83A1-F6EECF244321}">
                <p14:modId xmlns:p14="http://schemas.microsoft.com/office/powerpoint/2010/main" val="882936507"/>
              </p:ext>
            </p:extLst>
          </p:nvPr>
        </p:nvGraphicFramePr>
        <p:xfrm>
          <a:off x="368858" y="831281"/>
          <a:ext cx="11210128" cy="6764482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3F94C264-14F7-41ED-8ABB-AA2AECA25767}"/>
              </a:ext>
            </a:extLst>
          </p:cNvPr>
          <p:cNvSpPr txBox="1"/>
          <p:nvPr/>
        </p:nvSpPr>
        <p:spPr>
          <a:xfrm>
            <a:off x="596352" y="1424159"/>
            <a:ext cx="2913778" cy="58477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1600"/>
            </a:lvl1pPr>
          </a:lstStyle>
          <a:p>
            <a:r>
              <a:rPr lang="en-GB" dirty="0"/>
              <a:t>1. DHM &amp; </a:t>
            </a:r>
            <a:r>
              <a:rPr lang="en-GB" dirty="0" err="1"/>
              <a:t>UKCloud</a:t>
            </a:r>
            <a:r>
              <a:rPr lang="en-GB" dirty="0"/>
              <a:t> store patient identifiable </a:t>
            </a:r>
            <a:r>
              <a:rPr lang="en-GB" dirty="0" smtClean="0"/>
              <a:t>Web </a:t>
            </a:r>
            <a:r>
              <a:rPr lang="en-GB" dirty="0"/>
              <a:t>app dat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961927D-23F2-4812-A37C-5380071E0CBD}"/>
              </a:ext>
            </a:extLst>
          </p:cNvPr>
          <p:cNvSpPr txBox="1"/>
          <p:nvPr/>
        </p:nvSpPr>
        <p:spPr>
          <a:xfrm>
            <a:off x="4064652" y="1424159"/>
            <a:ext cx="2275990" cy="58477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1600"/>
            </a:lvl1pPr>
          </a:lstStyle>
          <a:p>
            <a:r>
              <a:rPr lang="en-GB" dirty="0"/>
              <a:t>2. DHM anonymises </a:t>
            </a:r>
            <a:r>
              <a:rPr lang="en-GB" dirty="0" smtClean="0"/>
              <a:t>Web </a:t>
            </a:r>
            <a:r>
              <a:rPr lang="en-GB" dirty="0"/>
              <a:t>app dat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5A43D71-DC92-44DB-B0DF-D50059740935}"/>
              </a:ext>
            </a:extLst>
          </p:cNvPr>
          <p:cNvSpPr txBox="1"/>
          <p:nvPr/>
        </p:nvSpPr>
        <p:spPr>
          <a:xfrm>
            <a:off x="7356406" y="1424159"/>
            <a:ext cx="2562243" cy="83099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1600"/>
            </a:lvl1pPr>
          </a:lstStyle>
          <a:p>
            <a:r>
              <a:rPr lang="en-GB" dirty="0"/>
              <a:t>3. ICL stores anonymised </a:t>
            </a:r>
            <a:r>
              <a:rPr lang="en-GB" dirty="0" smtClean="0"/>
              <a:t>Web </a:t>
            </a:r>
            <a:r>
              <a:rPr lang="en-GB" dirty="0"/>
              <a:t>app data and patient consent form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8B736570-B721-4E40-93E9-2B3FBF9CEDB1}"/>
              </a:ext>
            </a:extLst>
          </p:cNvPr>
          <p:cNvGrpSpPr/>
          <p:nvPr/>
        </p:nvGrpSpPr>
        <p:grpSpPr>
          <a:xfrm>
            <a:off x="10853062" y="3523844"/>
            <a:ext cx="1203906" cy="973391"/>
            <a:chOff x="6892273" y="2347485"/>
            <a:chExt cx="1203906" cy="973391"/>
          </a:xfrm>
          <a:solidFill>
            <a:schemeClr val="accent1">
              <a:lumMod val="75000"/>
            </a:schemeClr>
          </a:solidFill>
          <a:scene3d>
            <a:camera prst="orthographicFront"/>
            <a:lightRig rig="flat" dir="t"/>
          </a:scene3d>
        </p:grpSpPr>
        <p:sp>
          <p:nvSpPr>
            <p:cNvPr id="14" name="Oval 13">
              <a:extLst>
                <a:ext uri="{FF2B5EF4-FFF2-40B4-BE49-F238E27FC236}">
                  <a16:creationId xmlns:a16="http://schemas.microsoft.com/office/drawing/2014/main" id="{EAED48F7-5F00-484A-AC22-E274EE4BDCE1}"/>
                </a:ext>
              </a:extLst>
            </p:cNvPr>
            <p:cNvSpPr/>
            <p:nvPr/>
          </p:nvSpPr>
          <p:spPr>
            <a:xfrm>
              <a:off x="6892273" y="2347485"/>
              <a:ext cx="1203906" cy="973391"/>
            </a:xfrm>
            <a:prstGeom prst="ellipse">
              <a:avLst/>
            </a:prstGeom>
            <a:grpFill/>
            <a:sp3d prstMaterial="plastic">
              <a:bevelT w="120900" h="88900"/>
              <a:bevelB w="88900" h="31750" prst="angle"/>
            </a:sp3d>
          </p:spPr>
          <p:style>
            <a:lnRef idx="0">
              <a:schemeClr val="lt1">
                <a:hueOff val="0"/>
                <a:satOff val="0"/>
                <a:lumOff val="0"/>
                <a:alphaOff val="0"/>
              </a:schemeClr>
            </a:lnRef>
            <a:fillRef idx="3">
              <a:schemeClr val="accent2">
                <a:hueOff val="-1455363"/>
                <a:satOff val="-83928"/>
                <a:lumOff val="8628"/>
                <a:alphaOff val="0"/>
              </a:schemeClr>
            </a:fillRef>
            <a:effectRef idx="2">
              <a:schemeClr val="accent2">
                <a:hueOff val="-1455363"/>
                <a:satOff val="-83928"/>
                <a:lumOff val="8628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15" name="Oval 4">
              <a:extLst>
                <a:ext uri="{FF2B5EF4-FFF2-40B4-BE49-F238E27FC236}">
                  <a16:creationId xmlns:a16="http://schemas.microsoft.com/office/drawing/2014/main" id="{3DA3B45D-E43A-4227-9635-1CBD8BC05F14}"/>
                </a:ext>
              </a:extLst>
            </p:cNvPr>
            <p:cNvSpPr txBox="1"/>
            <p:nvPr/>
          </p:nvSpPr>
          <p:spPr>
            <a:xfrm>
              <a:off x="7068581" y="2490035"/>
              <a:ext cx="851290" cy="688291"/>
            </a:xfrm>
            <a:prstGeom prst="rect">
              <a:avLst/>
            </a:prstGeom>
            <a:grpFill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6350" tIns="6350" rIns="6350" bIns="6350" numCol="1" spcCol="1270" anchor="ctr" anchorCtr="0">
              <a:noAutofit/>
            </a:bodyPr>
            <a:lstStyle/>
            <a:p>
              <a:pPr marL="0" lvl="0" indent="0" algn="ctr" defTabSz="4445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GB" sz="1400" kern="1200" dirty="0"/>
                <a:t>Summary </a:t>
              </a:r>
              <a:r>
                <a:rPr lang="en-GB" sz="1400" kern="1200" dirty="0" smtClean="0"/>
                <a:t>Data</a:t>
              </a:r>
              <a:endParaRPr lang="en-GB" sz="1400" kern="1200" dirty="0"/>
            </a:p>
            <a:p>
              <a:pPr marL="0" lvl="0" indent="0" algn="ctr" defTabSz="4445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endParaRPr lang="en-GB" sz="1000" kern="1200" dirty="0"/>
            </a:p>
          </p:txBody>
        </p: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ED5235A2-CE23-4509-8BB0-22975B5F2DB6}"/>
              </a:ext>
            </a:extLst>
          </p:cNvPr>
          <p:cNvSpPr txBox="1"/>
          <p:nvPr/>
        </p:nvSpPr>
        <p:spPr>
          <a:xfrm>
            <a:off x="10538111" y="1414107"/>
            <a:ext cx="1477632" cy="83099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1600"/>
            </a:lvl1pPr>
          </a:lstStyle>
          <a:p>
            <a:r>
              <a:rPr lang="en-GB" dirty="0"/>
              <a:t>4. ICL sends summary data to AHA</a:t>
            </a:r>
          </a:p>
        </p:txBody>
      </p:sp>
    </p:spTree>
    <p:extLst>
      <p:ext uri="{BB962C8B-B14F-4D97-AF65-F5344CB8AC3E}">
        <p14:creationId xmlns:p14="http://schemas.microsoft.com/office/powerpoint/2010/main" val="1768251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03</Words>
  <Application>Microsoft Office PowerPoint</Application>
  <PresentationFormat>Widescreen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Imperial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oringer, Maria</dc:creator>
  <cp:lastModifiedBy>Woringer, Maria</cp:lastModifiedBy>
  <cp:revision>3</cp:revision>
  <dcterms:created xsi:type="dcterms:W3CDTF">2018-02-09T12:14:49Z</dcterms:created>
  <dcterms:modified xsi:type="dcterms:W3CDTF">2018-11-19T12:59:25Z</dcterms:modified>
</cp:coreProperties>
</file>